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4"/>
  </p:sldMasterIdLst>
  <p:notesMasterIdLst>
    <p:notesMasterId r:id="rId22"/>
  </p:notesMasterIdLst>
  <p:sldIdLst>
    <p:sldId id="256" r:id="rId5"/>
    <p:sldId id="274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70" r:id="rId15"/>
    <p:sldId id="271" r:id="rId16"/>
    <p:sldId id="268" r:id="rId17"/>
    <p:sldId id="269" r:id="rId18"/>
    <p:sldId id="276" r:id="rId19"/>
    <p:sldId id="272" r:id="rId20"/>
    <p:sldId id="273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67" d="100"/>
          <a:sy n="67" d="100"/>
        </p:scale>
        <p:origin x="288" y="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ableStyles" Target="tableStyles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notesMaster" Target="notesMasters/notesMaster1.xml"/><Relationship Id="rId27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yalakshmi Sridhar" userId="646a86f8-367a-44be-b6f0-8269940bf0d9" providerId="ADAL" clId="{29E418D4-C610-460F-84E1-35CA3DC3A1A0}"/>
    <pc:docChg chg="modSld">
      <pc:chgData name="Jayalakshmi Sridhar" userId="646a86f8-367a-44be-b6f0-8269940bf0d9" providerId="ADAL" clId="{29E418D4-C610-460F-84E1-35CA3DC3A1A0}" dt="2024-12-02T23:46:22.907" v="39" actId="947"/>
      <pc:docMkLst>
        <pc:docMk/>
      </pc:docMkLst>
      <pc:sldChg chg="modSp mod">
        <pc:chgData name="Jayalakshmi Sridhar" userId="646a86f8-367a-44be-b6f0-8269940bf0d9" providerId="ADAL" clId="{29E418D4-C610-460F-84E1-35CA3DC3A1A0}" dt="2024-12-02T23:46:22.907" v="39" actId="947"/>
        <pc:sldMkLst>
          <pc:docMk/>
          <pc:sldMk cId="2102506321" sldId="256"/>
        </pc:sldMkLst>
        <pc:spChg chg="mod">
          <ac:chgData name="Jayalakshmi Sridhar" userId="646a86f8-367a-44be-b6f0-8269940bf0d9" providerId="ADAL" clId="{29E418D4-C610-460F-84E1-35CA3DC3A1A0}" dt="2024-12-02T23:46:22.907" v="39" actId="947"/>
          <ac:spMkLst>
            <pc:docMk/>
            <pc:sldMk cId="2102506321" sldId="256"/>
            <ac:spMk id="2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A3CF02-E4B6-4CD0-9B9B-723B686688EE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88B07-28E7-4C0C-9F99-07B62F986B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752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C4107-9D57-402C-8E1D-696DD22DAE8B}" type="datetime1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79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22E34-EDAD-4A48-8458-261DC06B61B4}" type="datetime1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849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5046E-9C5E-4AC7-8EE6-70BCAE3A5B97}" type="datetime1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768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1457C-AC47-43F4-BBF7-F55026D992B3}" type="datetime1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743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1E6B82-CE64-4EBB-A712-119A0CC512F2}" type="datetime1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595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94E14-2DB6-44D4-86DD-CDCF96FD23AC}" type="datetime1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036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BF7B7-8FE9-4942-9E2E-53B1C311D1DF}" type="datetime1">
              <a:rPr lang="en-US" smtClean="0"/>
              <a:t>1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625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2240F-A13B-4F0A-9579-28A6EB25A8A9}" type="datetime1">
              <a:rPr lang="en-US" smtClean="0"/>
              <a:t>1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132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222B1-A0AE-4A6D-A4D6-22828852C763}" type="datetime1">
              <a:rPr lang="en-US" smtClean="0"/>
              <a:t>1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470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24CDE-E7CE-4AFB-BAAF-F712968FFA33}" type="datetime1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230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D4035-2C1E-4877-8F06-433CDEC57D97}" type="datetime1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72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C99DEB-7AD6-410D-9222-5B2AC8F7D6DA}" type="datetime1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CD9C0-BFF2-459C-8E88-84904738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469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gif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gif"/><Relationship Id="rId4" Type="http://schemas.openxmlformats.org/officeDocument/2006/relationships/image" Target="../media/image25.gi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jpeg"/><Relationship Id="rId3" Type="http://schemas.openxmlformats.org/officeDocument/2006/relationships/image" Target="../media/image30.jpeg"/><Relationship Id="rId7" Type="http://schemas.openxmlformats.org/officeDocument/2006/relationships/image" Target="../media/image34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jpeg"/><Relationship Id="rId5" Type="http://schemas.openxmlformats.org/officeDocument/2006/relationships/image" Target="../media/image32.jpeg"/><Relationship Id="rId4" Type="http://schemas.openxmlformats.org/officeDocument/2006/relationships/image" Target="../media/image31.jpeg"/><Relationship Id="rId9" Type="http://schemas.openxmlformats.org/officeDocument/2006/relationships/image" Target="../media/image36.jpe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eg"/><Relationship Id="rId3" Type="http://schemas.microsoft.com/office/2007/relationships/hdphoto" Target="../media/hdphoto5.wdp"/><Relationship Id="rId7" Type="http://schemas.openxmlformats.org/officeDocument/2006/relationships/image" Target="../media/image41.jpe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jpeg"/><Relationship Id="rId5" Type="http://schemas.openxmlformats.org/officeDocument/2006/relationships/image" Target="../media/image39.jpeg"/><Relationship Id="rId10" Type="http://schemas.openxmlformats.org/officeDocument/2006/relationships/image" Target="../media/image44.jpeg"/><Relationship Id="rId4" Type="http://schemas.openxmlformats.org/officeDocument/2006/relationships/image" Target="../media/image38.jpeg"/><Relationship Id="rId9" Type="http://schemas.openxmlformats.org/officeDocument/2006/relationships/image" Target="../media/image4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3.bin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4.bin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5.bin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6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440430" y="1794644"/>
            <a:ext cx="2779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Information</a:t>
            </a:r>
          </a:p>
        </p:txBody>
      </p:sp>
      <p:sp>
        <p:nvSpPr>
          <p:cNvPr id="2" name="Rectangle 1"/>
          <p:cNvSpPr/>
          <p:nvPr/>
        </p:nvSpPr>
        <p:spPr>
          <a:xfrm>
            <a:off x="3173835" y="2824774"/>
            <a:ext cx="6096000" cy="226036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Development of 6-Amido-4-aminoisoindolyn-1,3-diones as p70S6K1 inhibitors and potential breast cancer therapeutics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drian Thornton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Rajesh Komati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ogyou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Kim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Jamia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Myers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Kymmi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Petty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Rio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Sam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Elijah Johnson-Henderson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Keshunn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Reese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Lin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ran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Vaniyambadi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Sridhar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Christopher Williams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Jayalakshmi Sridhar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,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*</a:t>
            </a:r>
          </a:p>
          <a:p>
            <a:pPr algn="just">
              <a:lnSpc>
                <a:spcPct val="107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epartment of Chemistry and 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ivision of Pharmaceutical Sciences, College of Pharmacy, Xavier University of Louisiana, 1, Drexel Drive, New Orleans, LA, USA 70125</a:t>
            </a:r>
          </a:p>
          <a:p>
            <a:pPr algn="just">
              <a:lnSpc>
                <a:spcPct val="107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epartment of Chemistry, Nicholls State University, Thibodaux, LA, USA 70301 </a:t>
            </a:r>
          </a:p>
          <a:p>
            <a:pPr algn="just">
              <a:lnSpc>
                <a:spcPct val="107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epartment of Biology, University of New Orleans, LA, USA 70148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* Corresponding author. Email: jsridhar@xula.edu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5063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graph&#10;&#10;Description automatically generated">
            <a:extLst>
              <a:ext uri="{FF2B5EF4-FFF2-40B4-BE49-F238E27FC236}">
                <a16:creationId xmlns:a16="http://schemas.microsoft.com/office/drawing/2014/main" id="{CDFD2C8E-000C-F9DD-B7BA-18754AA550A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t="20259"/>
          <a:stretch/>
        </p:blipFill>
        <p:spPr>
          <a:xfrm>
            <a:off x="1173790" y="353287"/>
            <a:ext cx="10265819" cy="5767135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2554879"/>
              </p:ext>
            </p:extLst>
          </p:nvPr>
        </p:nvGraphicFramePr>
        <p:xfrm>
          <a:off x="1686554" y="1504290"/>
          <a:ext cx="2022475" cy="1195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2022053" imgH="1195912" progId="ChemDraw.Document.6.0">
                  <p:embed/>
                </p:oleObj>
              </mc:Choice>
              <mc:Fallback>
                <p:oleObj name="CS ChemDraw Drawing" r:id="rId3" imgW="2022053" imgH="1195912" progId="ChemDraw.Document.6.0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86554" y="1504290"/>
                        <a:ext cx="2022475" cy="1195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686554" y="2699677"/>
            <a:ext cx="2196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– Solvent: DMSO-d6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702040" y="6009841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10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605A7E5-DC22-46E6-B0EA-D7F10C9E7BCA}"/>
              </a:ext>
            </a:extLst>
          </p:cNvPr>
          <p:cNvSpPr txBox="1"/>
          <p:nvPr/>
        </p:nvSpPr>
        <p:spPr>
          <a:xfrm>
            <a:off x="1215441" y="6236466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of compound 5d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767494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grayscl/>
          </a:blip>
          <a:srcRect t="20460"/>
          <a:stretch/>
        </p:blipFill>
        <p:spPr>
          <a:xfrm>
            <a:off x="1385154" y="449176"/>
            <a:ext cx="9958936" cy="551959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4214640"/>
              </p:ext>
            </p:extLst>
          </p:nvPr>
        </p:nvGraphicFramePr>
        <p:xfrm>
          <a:off x="2202165" y="1712774"/>
          <a:ext cx="1617663" cy="121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1618257" imgH="1218643" progId="ChemDraw.Document.6.0">
                  <p:embed/>
                </p:oleObj>
              </mc:Choice>
              <mc:Fallback>
                <p:oleObj name="CS ChemDraw Drawing" r:id="rId3" imgW="1618257" imgH="1218643" progId="ChemDraw.Document.6.0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02165" y="1712774"/>
                        <a:ext cx="1617663" cy="121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056537" y="2931974"/>
            <a:ext cx="2127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– Solvent: DMSO-d6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596162" y="6072405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11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19F07D-371C-4A75-9111-BF9B8458DCEC}"/>
              </a:ext>
            </a:extLst>
          </p:cNvPr>
          <p:cNvSpPr txBox="1"/>
          <p:nvPr/>
        </p:nvSpPr>
        <p:spPr>
          <a:xfrm>
            <a:off x="1348338" y="6255511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of compound 5e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470211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1233487" y="324411"/>
            <a:ext cx="9944586" cy="5803641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1703329"/>
              </p:ext>
            </p:extLst>
          </p:nvPr>
        </p:nvGraphicFramePr>
        <p:xfrm>
          <a:off x="1815386" y="1593343"/>
          <a:ext cx="1617663" cy="121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1618257" imgH="1218643" progId="ChemDraw.Document.6.0">
                  <p:embed/>
                </p:oleObj>
              </mc:Choice>
              <mc:Fallback>
                <p:oleObj name="CS ChemDraw Drawing" r:id="rId3" imgW="1618257" imgH="1218643" progId="ChemDraw.Document.6.0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15386" y="1593343"/>
                        <a:ext cx="1617663" cy="121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525999" y="2812543"/>
            <a:ext cx="2196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– Solvent: DMSO-d6</a:t>
            </a: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610600" y="5980965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12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27C572-0313-4DE1-9174-58AE780F993E}"/>
              </a:ext>
            </a:extLst>
          </p:cNvPr>
          <p:cNvSpPr txBox="1"/>
          <p:nvPr/>
        </p:nvSpPr>
        <p:spPr>
          <a:xfrm>
            <a:off x="1233487" y="6256590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of compound 5e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40130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746"/>
          <a:stretch/>
        </p:blipFill>
        <p:spPr>
          <a:xfrm>
            <a:off x="1286203" y="447137"/>
            <a:ext cx="9820169" cy="5389477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2270098"/>
              </p:ext>
            </p:extLst>
          </p:nvPr>
        </p:nvGraphicFramePr>
        <p:xfrm>
          <a:off x="2317258" y="1193023"/>
          <a:ext cx="2282825" cy="1106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2282542" imgH="1106141" progId="ChemDraw.Document.6.0">
                  <p:embed/>
                </p:oleObj>
              </mc:Choice>
              <mc:Fallback>
                <p:oleObj name="CS ChemDraw Drawing" r:id="rId3" imgW="2282542" imgH="1106141" progId="ChemDraw.Document.6.0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17258" y="1193023"/>
                        <a:ext cx="2282825" cy="1106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317258" y="2299510"/>
            <a:ext cx="2127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– Solvent: DMSO-d6</a:t>
            </a: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663539" y="5764396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13</a:t>
            </a:fld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E944529-8D1A-4C55-BEA3-A856B217CEEC}"/>
              </a:ext>
            </a:extLst>
          </p:cNvPr>
          <p:cNvSpPr txBox="1"/>
          <p:nvPr/>
        </p:nvSpPr>
        <p:spPr>
          <a:xfrm>
            <a:off x="1348338" y="6255511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of compound 5f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4084943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349"/>
          <a:stretch/>
        </p:blipFill>
        <p:spPr>
          <a:xfrm>
            <a:off x="1032484" y="293133"/>
            <a:ext cx="10427703" cy="6084916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4858087"/>
              </p:ext>
            </p:extLst>
          </p:nvPr>
        </p:nvGraphicFramePr>
        <p:xfrm>
          <a:off x="1363481" y="1845354"/>
          <a:ext cx="2282825" cy="1106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2282542" imgH="1106141" progId="ChemDraw.Document.6.0">
                  <p:embed/>
                </p:oleObj>
              </mc:Choice>
              <mc:Fallback>
                <p:oleObj name="CS ChemDraw Drawing" r:id="rId3" imgW="2282542" imgH="1106141" progId="ChemDraw.Document.6.0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63481" y="1845354"/>
                        <a:ext cx="2282825" cy="1106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564500" y="3082050"/>
            <a:ext cx="2196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– Solvent: DMSO-d6</a:t>
            </a: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649101" y="6250472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14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804B03-528F-4880-B6FE-D8CC2A09D702}"/>
              </a:ext>
            </a:extLst>
          </p:cNvPr>
          <p:cNvSpPr txBox="1"/>
          <p:nvPr/>
        </p:nvSpPr>
        <p:spPr>
          <a:xfrm>
            <a:off x="984435" y="6426367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of compound 5f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683886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1688303" y="1858763"/>
            <a:ext cx="8706189" cy="4129166"/>
            <a:chOff x="817911" y="704761"/>
            <a:chExt cx="8706189" cy="4129166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7911" y="704761"/>
              <a:ext cx="2776121" cy="196691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537827" y="880169"/>
              <a:ext cx="105620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mpound 4</a:t>
              </a:r>
            </a:p>
          </p:txBody>
        </p:sp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7248" y="2850610"/>
              <a:ext cx="2761453" cy="198331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2386233" y="3026019"/>
              <a:ext cx="12077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mpound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c</a:t>
              </a:r>
            </a:p>
          </p:txBody>
        </p:sp>
        <p:pic>
          <p:nvPicPr>
            <p:cNvPr id="10" name="Picture 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1608" y="2850610"/>
              <a:ext cx="2776121" cy="198331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5255269" y="3026018"/>
              <a:ext cx="12077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mpound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d</a:t>
              </a:r>
            </a:p>
          </p:txBody>
        </p:sp>
        <p:pic>
          <p:nvPicPr>
            <p:cNvPr id="12" name="Picture 11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35512" y="2827204"/>
              <a:ext cx="2888588" cy="198331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8306530" y="2986654"/>
              <a:ext cx="120779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mpound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f</a:t>
              </a: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1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35512" y="704761"/>
              <a:ext cx="2888588" cy="19937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8306530" y="875494"/>
              <a:ext cx="120779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mpound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b</a:t>
              </a: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Picture 15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1608" y="704761"/>
              <a:ext cx="2776121" cy="197711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TextBox 16"/>
            <p:cNvSpPr txBox="1"/>
            <p:nvPr/>
          </p:nvSpPr>
          <p:spPr>
            <a:xfrm>
              <a:off x="5255269" y="875495"/>
              <a:ext cx="12077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mpound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a</a:t>
              </a: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1642584" y="1048753"/>
            <a:ext cx="87519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-point dose response curves for compound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, 5a, 5b, 5c, 5d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f. </a:t>
            </a:r>
          </a:p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Screen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chemical Kinase Profiling Service’ by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moFishe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ientific was used to obtain the IC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926910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D6E8E967-46D2-4453-8D26-C9BC22866DB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01" t="25880" r="20471" b="32407"/>
          <a:stretch/>
        </p:blipFill>
        <p:spPr>
          <a:xfrm>
            <a:off x="1309567" y="1002342"/>
            <a:ext cx="2137998" cy="186137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2513B16-85DC-47AC-A152-5BBF3B42C85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78" t="27786" r="20844" b="33269"/>
          <a:stretch/>
        </p:blipFill>
        <p:spPr>
          <a:xfrm>
            <a:off x="3637672" y="3902475"/>
            <a:ext cx="2028964" cy="185175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7D2F049-9E2B-40DE-84E1-DFFAE98A672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88" t="26330" r="17739" b="32956"/>
          <a:stretch/>
        </p:blipFill>
        <p:spPr>
          <a:xfrm>
            <a:off x="1341490" y="3892858"/>
            <a:ext cx="2274998" cy="18613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E618C51-FD96-4630-A07D-4FEC62FD2628}"/>
              </a:ext>
            </a:extLst>
          </p:cNvPr>
          <p:cNvSpPr txBox="1"/>
          <p:nvPr/>
        </p:nvSpPr>
        <p:spPr>
          <a:xfrm>
            <a:off x="3762785" y="3973563"/>
            <a:ext cx="163887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t-S6 ribosomal prote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D79AF3C-CCFA-42AC-BC3B-0E64694D8593}"/>
              </a:ext>
            </a:extLst>
          </p:cNvPr>
          <p:cNvCxnSpPr>
            <a:cxnSpLocks/>
          </p:cNvCxnSpPr>
          <p:nvPr/>
        </p:nvCxnSpPr>
        <p:spPr>
          <a:xfrm>
            <a:off x="1273724" y="3966276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05696AB-D982-4C65-B457-B907FEC0CFE9}"/>
              </a:ext>
            </a:extLst>
          </p:cNvPr>
          <p:cNvCxnSpPr>
            <a:cxnSpLocks/>
          </p:cNvCxnSpPr>
          <p:nvPr/>
        </p:nvCxnSpPr>
        <p:spPr>
          <a:xfrm>
            <a:off x="1273724" y="4147180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519E007-7D4A-4D9C-A03A-6EB309B507DF}"/>
              </a:ext>
            </a:extLst>
          </p:cNvPr>
          <p:cNvCxnSpPr>
            <a:cxnSpLocks/>
          </p:cNvCxnSpPr>
          <p:nvPr/>
        </p:nvCxnSpPr>
        <p:spPr>
          <a:xfrm>
            <a:off x="1273724" y="4320335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5B194E6-F8CD-447A-B70B-5F30C544CAD6}"/>
              </a:ext>
            </a:extLst>
          </p:cNvPr>
          <p:cNvCxnSpPr>
            <a:cxnSpLocks/>
          </p:cNvCxnSpPr>
          <p:nvPr/>
        </p:nvCxnSpPr>
        <p:spPr>
          <a:xfrm>
            <a:off x="1273724" y="4657951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111DE11C-0532-4225-8557-C13883AF949A}"/>
              </a:ext>
            </a:extLst>
          </p:cNvPr>
          <p:cNvCxnSpPr>
            <a:cxnSpLocks/>
          </p:cNvCxnSpPr>
          <p:nvPr/>
        </p:nvCxnSpPr>
        <p:spPr>
          <a:xfrm>
            <a:off x="1273724" y="4818290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DEAFA89-5F56-4BF1-8818-0EE608F0E190}"/>
              </a:ext>
            </a:extLst>
          </p:cNvPr>
          <p:cNvCxnSpPr>
            <a:cxnSpLocks/>
          </p:cNvCxnSpPr>
          <p:nvPr/>
        </p:nvCxnSpPr>
        <p:spPr>
          <a:xfrm>
            <a:off x="1273724" y="5045255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8FA375A-4D4A-4CAD-885A-1F87A2AE7441}"/>
              </a:ext>
            </a:extLst>
          </p:cNvPr>
          <p:cNvCxnSpPr>
            <a:cxnSpLocks/>
          </p:cNvCxnSpPr>
          <p:nvPr/>
        </p:nvCxnSpPr>
        <p:spPr>
          <a:xfrm>
            <a:off x="1273724" y="5132173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759DAD7-9687-4D2C-94E1-0382E6F0F8EA}"/>
              </a:ext>
            </a:extLst>
          </p:cNvPr>
          <p:cNvCxnSpPr>
            <a:cxnSpLocks/>
          </p:cNvCxnSpPr>
          <p:nvPr/>
        </p:nvCxnSpPr>
        <p:spPr>
          <a:xfrm>
            <a:off x="1273724" y="4452164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4CE882B-704A-4EE6-8F3B-C919107E91BD}"/>
              </a:ext>
            </a:extLst>
          </p:cNvPr>
          <p:cNvSpPr txBox="1"/>
          <p:nvPr/>
        </p:nvSpPr>
        <p:spPr>
          <a:xfrm>
            <a:off x="258582" y="1121145"/>
            <a:ext cx="9557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DA1C633-B4C4-4FD6-A83B-3750F26EC86B}"/>
              </a:ext>
            </a:extLst>
          </p:cNvPr>
          <p:cNvSpPr txBox="1"/>
          <p:nvPr/>
        </p:nvSpPr>
        <p:spPr>
          <a:xfrm>
            <a:off x="390574" y="4028497"/>
            <a:ext cx="874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F1AE25-C9D1-4F3D-A155-806BB6058F42}"/>
              </a:ext>
            </a:extLst>
          </p:cNvPr>
          <p:cNvSpPr txBox="1"/>
          <p:nvPr/>
        </p:nvSpPr>
        <p:spPr>
          <a:xfrm>
            <a:off x="321731" y="4178522"/>
            <a:ext cx="9366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9613A5D-F5D4-4F01-BA23-AF5AFDBE16F1}"/>
              </a:ext>
            </a:extLst>
          </p:cNvPr>
          <p:cNvSpPr txBox="1"/>
          <p:nvPr/>
        </p:nvSpPr>
        <p:spPr>
          <a:xfrm>
            <a:off x="507160" y="4706832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E0B1867-11BB-4211-8AEE-0702A806633F}"/>
              </a:ext>
            </a:extLst>
          </p:cNvPr>
          <p:cNvSpPr txBox="1"/>
          <p:nvPr/>
        </p:nvSpPr>
        <p:spPr>
          <a:xfrm>
            <a:off x="357732" y="4329696"/>
            <a:ext cx="9074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0593D8C-AA1F-4008-A7DB-8C162CC53604}"/>
              </a:ext>
            </a:extLst>
          </p:cNvPr>
          <p:cNvSpPr txBox="1"/>
          <p:nvPr/>
        </p:nvSpPr>
        <p:spPr>
          <a:xfrm>
            <a:off x="507160" y="4543317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232075A-6399-45CF-BA56-B8923AEF2085}"/>
              </a:ext>
            </a:extLst>
          </p:cNvPr>
          <p:cNvSpPr txBox="1"/>
          <p:nvPr/>
        </p:nvSpPr>
        <p:spPr>
          <a:xfrm>
            <a:off x="507160" y="4931620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404AFA5-90C9-406D-B67E-647945500A73}"/>
              </a:ext>
            </a:extLst>
          </p:cNvPr>
          <p:cNvSpPr txBox="1"/>
          <p:nvPr/>
        </p:nvSpPr>
        <p:spPr>
          <a:xfrm>
            <a:off x="507160" y="5025497"/>
            <a:ext cx="758003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2C092318-52F0-491A-984A-5F63512CA14C}"/>
              </a:ext>
            </a:extLst>
          </p:cNvPr>
          <p:cNvCxnSpPr>
            <a:cxnSpLocks/>
          </p:cNvCxnSpPr>
          <p:nvPr/>
        </p:nvCxnSpPr>
        <p:spPr>
          <a:xfrm>
            <a:off x="1273716" y="5294099"/>
            <a:ext cx="151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1D836E-BE3E-4DF1-93D0-D30DDCD9B63B}"/>
              </a:ext>
            </a:extLst>
          </p:cNvPr>
          <p:cNvSpPr txBox="1"/>
          <p:nvPr/>
        </p:nvSpPr>
        <p:spPr>
          <a:xfrm>
            <a:off x="507160" y="5187423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3FD2E810-E7AA-4BF0-B375-09D4B92AFFC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002" t="25880" r="20625" b="32407"/>
          <a:stretch/>
        </p:blipFill>
        <p:spPr>
          <a:xfrm>
            <a:off x="3552967" y="999418"/>
            <a:ext cx="1929769" cy="1861373"/>
          </a:xfrm>
          <a:prstGeom prst="rect">
            <a:avLst/>
          </a:prstGeom>
        </p:spPr>
      </p:pic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6F0433E8-8A3A-430B-AC11-BD2C00139A3A}"/>
              </a:ext>
            </a:extLst>
          </p:cNvPr>
          <p:cNvCxnSpPr>
            <a:cxnSpLocks/>
          </p:cNvCxnSpPr>
          <p:nvPr/>
        </p:nvCxnSpPr>
        <p:spPr>
          <a:xfrm>
            <a:off x="1214325" y="1208343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1122176-DA09-4F58-8990-763BE97ED620}"/>
              </a:ext>
            </a:extLst>
          </p:cNvPr>
          <p:cNvCxnSpPr>
            <a:cxnSpLocks/>
          </p:cNvCxnSpPr>
          <p:nvPr/>
        </p:nvCxnSpPr>
        <p:spPr>
          <a:xfrm>
            <a:off x="1214325" y="1392421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9DCCA32C-F23E-49E4-B696-4462AD95C89A}"/>
              </a:ext>
            </a:extLst>
          </p:cNvPr>
          <p:cNvCxnSpPr>
            <a:cxnSpLocks/>
          </p:cNvCxnSpPr>
          <p:nvPr/>
        </p:nvCxnSpPr>
        <p:spPr>
          <a:xfrm>
            <a:off x="1214325" y="1565576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A943AD5-65B5-489F-9B0B-9639D59D8CAB}"/>
              </a:ext>
            </a:extLst>
          </p:cNvPr>
          <p:cNvCxnSpPr>
            <a:cxnSpLocks/>
          </p:cNvCxnSpPr>
          <p:nvPr/>
        </p:nvCxnSpPr>
        <p:spPr>
          <a:xfrm>
            <a:off x="1214325" y="1886258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1B61F967-D767-44F8-BC86-1C8627385776}"/>
              </a:ext>
            </a:extLst>
          </p:cNvPr>
          <p:cNvCxnSpPr>
            <a:cxnSpLocks/>
          </p:cNvCxnSpPr>
          <p:nvPr/>
        </p:nvCxnSpPr>
        <p:spPr>
          <a:xfrm>
            <a:off x="1214325" y="2046597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3A5C36B-326D-4E68-8915-B8614FF7EF37}"/>
              </a:ext>
            </a:extLst>
          </p:cNvPr>
          <p:cNvCxnSpPr>
            <a:cxnSpLocks/>
          </p:cNvCxnSpPr>
          <p:nvPr/>
        </p:nvCxnSpPr>
        <p:spPr>
          <a:xfrm>
            <a:off x="1214325" y="2283086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5F5A9083-461E-4568-80C7-7A521C0F435D}"/>
              </a:ext>
            </a:extLst>
          </p:cNvPr>
          <p:cNvCxnSpPr>
            <a:cxnSpLocks/>
          </p:cNvCxnSpPr>
          <p:nvPr/>
        </p:nvCxnSpPr>
        <p:spPr>
          <a:xfrm>
            <a:off x="1214325" y="2396198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B5E88491-63A3-44C2-A965-2950AB4376B9}"/>
              </a:ext>
            </a:extLst>
          </p:cNvPr>
          <p:cNvCxnSpPr>
            <a:cxnSpLocks/>
          </p:cNvCxnSpPr>
          <p:nvPr/>
        </p:nvCxnSpPr>
        <p:spPr>
          <a:xfrm>
            <a:off x="1214325" y="1680471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7E99F787-8ABE-4BAA-89F6-53DAAE9F525A}"/>
              </a:ext>
            </a:extLst>
          </p:cNvPr>
          <p:cNvSpPr txBox="1"/>
          <p:nvPr/>
        </p:nvSpPr>
        <p:spPr>
          <a:xfrm>
            <a:off x="363984" y="1305851"/>
            <a:ext cx="874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B7854C6-8CB7-4B69-81F1-74EB82F9B109}"/>
              </a:ext>
            </a:extLst>
          </p:cNvPr>
          <p:cNvSpPr txBox="1"/>
          <p:nvPr/>
        </p:nvSpPr>
        <p:spPr>
          <a:xfrm>
            <a:off x="301942" y="1473447"/>
            <a:ext cx="9366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7B70247-404E-4730-9B25-C1598062437B}"/>
              </a:ext>
            </a:extLst>
          </p:cNvPr>
          <p:cNvSpPr txBox="1"/>
          <p:nvPr/>
        </p:nvSpPr>
        <p:spPr>
          <a:xfrm>
            <a:off x="480569" y="1967252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CA4FDC5-6C94-4E8A-99BE-78E365FF1F88}"/>
              </a:ext>
            </a:extLst>
          </p:cNvPr>
          <p:cNvSpPr txBox="1"/>
          <p:nvPr/>
        </p:nvSpPr>
        <p:spPr>
          <a:xfrm>
            <a:off x="331142" y="1590116"/>
            <a:ext cx="9074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4F78891-005C-4412-8096-BF1AE08E0CE6}"/>
              </a:ext>
            </a:extLst>
          </p:cNvPr>
          <p:cNvSpPr txBox="1"/>
          <p:nvPr/>
        </p:nvSpPr>
        <p:spPr>
          <a:xfrm>
            <a:off x="480569" y="1803737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FD8BF0F-171F-47F1-8CD0-7F65D3C12CED}"/>
              </a:ext>
            </a:extLst>
          </p:cNvPr>
          <p:cNvSpPr txBox="1"/>
          <p:nvPr/>
        </p:nvSpPr>
        <p:spPr>
          <a:xfrm>
            <a:off x="480569" y="2192040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80F2830-1017-4647-8DC1-0021A2513417}"/>
              </a:ext>
            </a:extLst>
          </p:cNvPr>
          <p:cNvSpPr txBox="1"/>
          <p:nvPr/>
        </p:nvSpPr>
        <p:spPr>
          <a:xfrm>
            <a:off x="480569" y="2321635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A9C464AD-E68D-4FC0-A6A7-EA68E01A7C00}"/>
              </a:ext>
            </a:extLst>
          </p:cNvPr>
          <p:cNvCxnSpPr>
            <a:cxnSpLocks/>
          </p:cNvCxnSpPr>
          <p:nvPr/>
        </p:nvCxnSpPr>
        <p:spPr>
          <a:xfrm>
            <a:off x="1214317" y="2558124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F6D63826-BA03-4D5F-9173-0397B7E5E1C3}"/>
              </a:ext>
            </a:extLst>
          </p:cNvPr>
          <p:cNvSpPr txBox="1"/>
          <p:nvPr/>
        </p:nvSpPr>
        <p:spPr>
          <a:xfrm>
            <a:off x="480561" y="2483561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B56BCAA-E593-419A-B9F4-42D0D47E84DA}"/>
              </a:ext>
            </a:extLst>
          </p:cNvPr>
          <p:cNvSpPr txBox="1"/>
          <p:nvPr/>
        </p:nvSpPr>
        <p:spPr>
          <a:xfrm>
            <a:off x="309427" y="3842758"/>
            <a:ext cx="9557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F2F9B464-5679-45FE-9704-C937C32FBB5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69" t="22896" r="22033" b="37261"/>
          <a:stretch/>
        </p:blipFill>
        <p:spPr>
          <a:xfrm>
            <a:off x="7092472" y="3966276"/>
            <a:ext cx="2211402" cy="1816758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B6B9C598-FA0D-404B-9893-BE47DBD5C89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69" t="22896" r="24183" b="37261"/>
          <a:stretch/>
        </p:blipFill>
        <p:spPr>
          <a:xfrm>
            <a:off x="9393046" y="3954405"/>
            <a:ext cx="2000648" cy="1816758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755BBFD5-6357-4A9E-A5DC-EFB132E6EEE8}"/>
              </a:ext>
            </a:extLst>
          </p:cNvPr>
          <p:cNvSpPr txBox="1"/>
          <p:nvPr/>
        </p:nvSpPr>
        <p:spPr>
          <a:xfrm>
            <a:off x="3542807" y="1141353"/>
            <a:ext cx="19343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p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S240/244-S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ribosomal prote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80288164-936B-44FA-84A0-0E563B07BB66}"/>
              </a:ext>
            </a:extLst>
          </p:cNvPr>
          <p:cNvCxnSpPr>
            <a:cxnSpLocks/>
          </p:cNvCxnSpPr>
          <p:nvPr/>
        </p:nvCxnSpPr>
        <p:spPr>
          <a:xfrm>
            <a:off x="6993131" y="4101427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BFE35C12-BF74-4ED0-9EC6-CDDAD2E62F3A}"/>
              </a:ext>
            </a:extLst>
          </p:cNvPr>
          <p:cNvCxnSpPr>
            <a:cxnSpLocks/>
          </p:cNvCxnSpPr>
          <p:nvPr/>
        </p:nvCxnSpPr>
        <p:spPr>
          <a:xfrm>
            <a:off x="6993131" y="4256930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32B700FB-C915-4140-B944-5A515F25B1E8}"/>
              </a:ext>
            </a:extLst>
          </p:cNvPr>
          <p:cNvCxnSpPr>
            <a:cxnSpLocks/>
          </p:cNvCxnSpPr>
          <p:nvPr/>
        </p:nvCxnSpPr>
        <p:spPr>
          <a:xfrm>
            <a:off x="6993131" y="4430085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ECAD2F4F-FF07-4ACD-8BF3-CE5E2214748D}"/>
              </a:ext>
            </a:extLst>
          </p:cNvPr>
          <p:cNvCxnSpPr>
            <a:cxnSpLocks/>
          </p:cNvCxnSpPr>
          <p:nvPr/>
        </p:nvCxnSpPr>
        <p:spPr>
          <a:xfrm>
            <a:off x="6993131" y="4760291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A6FD6722-2823-44F5-B5DC-F7FAC9D62EED}"/>
              </a:ext>
            </a:extLst>
          </p:cNvPr>
          <p:cNvCxnSpPr>
            <a:cxnSpLocks/>
          </p:cNvCxnSpPr>
          <p:nvPr/>
        </p:nvCxnSpPr>
        <p:spPr>
          <a:xfrm>
            <a:off x="6993131" y="4920630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D340128-188A-478F-91D7-2BEE38715F75}"/>
              </a:ext>
            </a:extLst>
          </p:cNvPr>
          <p:cNvCxnSpPr>
            <a:cxnSpLocks/>
          </p:cNvCxnSpPr>
          <p:nvPr/>
        </p:nvCxnSpPr>
        <p:spPr>
          <a:xfrm>
            <a:off x="6993131" y="5147595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D5BF1070-8BF1-49AF-B47E-AF8FF3529ECE}"/>
              </a:ext>
            </a:extLst>
          </p:cNvPr>
          <p:cNvCxnSpPr>
            <a:cxnSpLocks/>
          </p:cNvCxnSpPr>
          <p:nvPr/>
        </p:nvCxnSpPr>
        <p:spPr>
          <a:xfrm>
            <a:off x="6993131" y="5234513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366EAD4D-3CB3-495A-998B-48AB09F7DD7A}"/>
              </a:ext>
            </a:extLst>
          </p:cNvPr>
          <p:cNvCxnSpPr>
            <a:cxnSpLocks/>
          </p:cNvCxnSpPr>
          <p:nvPr/>
        </p:nvCxnSpPr>
        <p:spPr>
          <a:xfrm>
            <a:off x="6993131" y="4554504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C5586B00-4611-49A9-ACE6-DCC37B324885}"/>
              </a:ext>
            </a:extLst>
          </p:cNvPr>
          <p:cNvSpPr txBox="1"/>
          <p:nvPr/>
        </p:nvSpPr>
        <p:spPr>
          <a:xfrm>
            <a:off x="6135879" y="4161646"/>
            <a:ext cx="8814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B2C56FF-3ECE-48B8-A777-DE5BF248E4EC}"/>
              </a:ext>
            </a:extLst>
          </p:cNvPr>
          <p:cNvSpPr txBox="1"/>
          <p:nvPr/>
        </p:nvSpPr>
        <p:spPr>
          <a:xfrm>
            <a:off x="6073349" y="4329242"/>
            <a:ext cx="9440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A8B1B4C-DE6B-4F28-9EBA-453FF926CDCE}"/>
              </a:ext>
            </a:extLst>
          </p:cNvPr>
          <p:cNvSpPr txBox="1"/>
          <p:nvPr/>
        </p:nvSpPr>
        <p:spPr>
          <a:xfrm>
            <a:off x="6253387" y="4826932"/>
            <a:ext cx="763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9FD8D14-0D09-437F-92D8-20B9FC4690B1}"/>
              </a:ext>
            </a:extLst>
          </p:cNvPr>
          <p:cNvSpPr txBox="1"/>
          <p:nvPr/>
        </p:nvSpPr>
        <p:spPr>
          <a:xfrm>
            <a:off x="6102779" y="4455435"/>
            <a:ext cx="9145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4DAF262-7FCD-4125-B651-852F4F7E048B}"/>
              </a:ext>
            </a:extLst>
          </p:cNvPr>
          <p:cNvSpPr txBox="1"/>
          <p:nvPr/>
        </p:nvSpPr>
        <p:spPr>
          <a:xfrm>
            <a:off x="6253387" y="4663417"/>
            <a:ext cx="763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62C8BF6-8E18-4D02-ABD6-10C317DAB97B}"/>
              </a:ext>
            </a:extLst>
          </p:cNvPr>
          <p:cNvSpPr txBox="1"/>
          <p:nvPr/>
        </p:nvSpPr>
        <p:spPr>
          <a:xfrm>
            <a:off x="6253387" y="5051720"/>
            <a:ext cx="763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27BD00D-3C7C-440F-9FA0-0476A6995922}"/>
              </a:ext>
            </a:extLst>
          </p:cNvPr>
          <p:cNvSpPr txBox="1"/>
          <p:nvPr/>
        </p:nvSpPr>
        <p:spPr>
          <a:xfrm>
            <a:off x="6253387" y="5145597"/>
            <a:ext cx="763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EAE7B268-CD3C-4170-A84B-F578A31F08FE}"/>
              </a:ext>
            </a:extLst>
          </p:cNvPr>
          <p:cNvCxnSpPr>
            <a:cxnSpLocks/>
          </p:cNvCxnSpPr>
          <p:nvPr/>
        </p:nvCxnSpPr>
        <p:spPr>
          <a:xfrm>
            <a:off x="6993123" y="5396439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AC503A93-284A-482A-BC7B-FBF932A364ED}"/>
              </a:ext>
            </a:extLst>
          </p:cNvPr>
          <p:cNvSpPr txBox="1"/>
          <p:nvPr/>
        </p:nvSpPr>
        <p:spPr>
          <a:xfrm>
            <a:off x="6253379" y="5307523"/>
            <a:ext cx="763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0D02F65-2B6E-4C7A-B60A-83513230BE61}"/>
              </a:ext>
            </a:extLst>
          </p:cNvPr>
          <p:cNvSpPr txBox="1"/>
          <p:nvPr/>
        </p:nvSpPr>
        <p:spPr>
          <a:xfrm>
            <a:off x="6078435" y="3959800"/>
            <a:ext cx="9632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68D55F1-E930-4085-B2F9-D5015F0ABD3D}"/>
              </a:ext>
            </a:extLst>
          </p:cNvPr>
          <p:cNvSpPr txBox="1"/>
          <p:nvPr/>
        </p:nvSpPr>
        <p:spPr>
          <a:xfrm>
            <a:off x="10064266" y="3996103"/>
            <a:ext cx="7557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GADPH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Picture 86">
            <a:extLst>
              <a:ext uri="{FF2B5EF4-FFF2-40B4-BE49-F238E27FC236}">
                <a16:creationId xmlns:a16="http://schemas.microsoft.com/office/drawing/2014/main" id="{54B46EAE-3638-4FB2-BFE0-2CCF66E996F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66" t="29204" r="20614" b="30402"/>
          <a:stretch/>
        </p:blipFill>
        <p:spPr>
          <a:xfrm>
            <a:off x="6599518" y="957097"/>
            <a:ext cx="2211402" cy="1918266"/>
          </a:xfrm>
          <a:prstGeom prst="rect">
            <a:avLst/>
          </a:prstGeom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FF288A3A-0F55-4BF9-B184-6AD2569FDB72}"/>
              </a:ext>
            </a:extLst>
          </p:cNvPr>
          <p:cNvSpPr txBox="1"/>
          <p:nvPr/>
        </p:nvSpPr>
        <p:spPr>
          <a:xfrm>
            <a:off x="5549992" y="1119514"/>
            <a:ext cx="9557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AD5348C7-55FD-4892-9021-F4C9E7A818EF}"/>
              </a:ext>
            </a:extLst>
          </p:cNvPr>
          <p:cNvCxnSpPr>
            <a:cxnSpLocks/>
          </p:cNvCxnSpPr>
          <p:nvPr/>
        </p:nvCxnSpPr>
        <p:spPr>
          <a:xfrm>
            <a:off x="6505735" y="1206712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F5AF641B-9CDD-4847-941C-303767006A8B}"/>
              </a:ext>
            </a:extLst>
          </p:cNvPr>
          <p:cNvCxnSpPr>
            <a:cxnSpLocks/>
          </p:cNvCxnSpPr>
          <p:nvPr/>
        </p:nvCxnSpPr>
        <p:spPr>
          <a:xfrm>
            <a:off x="6505735" y="1390790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A7FEBDBC-BD8B-43A1-8FAD-09FD97CC8610}"/>
              </a:ext>
            </a:extLst>
          </p:cNvPr>
          <p:cNvCxnSpPr>
            <a:cxnSpLocks/>
          </p:cNvCxnSpPr>
          <p:nvPr/>
        </p:nvCxnSpPr>
        <p:spPr>
          <a:xfrm>
            <a:off x="6505735" y="1589345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F89603BD-2CFE-47F9-9034-92486C8D6740}"/>
              </a:ext>
            </a:extLst>
          </p:cNvPr>
          <p:cNvCxnSpPr>
            <a:cxnSpLocks/>
          </p:cNvCxnSpPr>
          <p:nvPr/>
        </p:nvCxnSpPr>
        <p:spPr>
          <a:xfrm>
            <a:off x="6505735" y="1936221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24F44920-8DFF-4FB8-9766-D80E8805A7D9}"/>
              </a:ext>
            </a:extLst>
          </p:cNvPr>
          <p:cNvCxnSpPr>
            <a:cxnSpLocks/>
          </p:cNvCxnSpPr>
          <p:nvPr/>
        </p:nvCxnSpPr>
        <p:spPr>
          <a:xfrm>
            <a:off x="6505735" y="2096560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8892BC79-F312-4DC5-A578-A9E785C2E5CC}"/>
              </a:ext>
            </a:extLst>
          </p:cNvPr>
          <p:cNvCxnSpPr>
            <a:cxnSpLocks/>
          </p:cNvCxnSpPr>
          <p:nvPr/>
        </p:nvCxnSpPr>
        <p:spPr>
          <a:xfrm>
            <a:off x="6505735" y="2333049"/>
            <a:ext cx="95250" cy="0"/>
          </a:xfrm>
          <a:prstGeom prst="line">
            <a:avLst/>
          </a:prstGeom>
          <a:ln w="381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F01A643E-A804-4F56-AB2D-B8C2ACABE41F}"/>
              </a:ext>
            </a:extLst>
          </p:cNvPr>
          <p:cNvCxnSpPr>
            <a:cxnSpLocks/>
          </p:cNvCxnSpPr>
          <p:nvPr/>
        </p:nvCxnSpPr>
        <p:spPr>
          <a:xfrm>
            <a:off x="6505735" y="2446161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B9A19479-1C39-420C-A10B-A075B0FD033F}"/>
              </a:ext>
            </a:extLst>
          </p:cNvPr>
          <p:cNvCxnSpPr>
            <a:cxnSpLocks/>
          </p:cNvCxnSpPr>
          <p:nvPr/>
        </p:nvCxnSpPr>
        <p:spPr>
          <a:xfrm>
            <a:off x="6505735" y="1704240"/>
            <a:ext cx="95250" cy="0"/>
          </a:xfrm>
          <a:prstGeom prst="line">
            <a:avLst/>
          </a:prstGeom>
          <a:ln w="381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A05EAFA4-4D80-4BF9-8B9B-0BC9DDCE0F12}"/>
              </a:ext>
            </a:extLst>
          </p:cNvPr>
          <p:cNvSpPr txBox="1"/>
          <p:nvPr/>
        </p:nvSpPr>
        <p:spPr>
          <a:xfrm>
            <a:off x="5655394" y="1304220"/>
            <a:ext cx="874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629DFFB-D022-4805-8058-97849E65F59D}"/>
              </a:ext>
            </a:extLst>
          </p:cNvPr>
          <p:cNvSpPr txBox="1"/>
          <p:nvPr/>
        </p:nvSpPr>
        <p:spPr>
          <a:xfrm>
            <a:off x="5593352" y="1497216"/>
            <a:ext cx="9366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4B37358-120D-43D1-BDFE-517138D9F62E}"/>
              </a:ext>
            </a:extLst>
          </p:cNvPr>
          <p:cNvSpPr txBox="1"/>
          <p:nvPr/>
        </p:nvSpPr>
        <p:spPr>
          <a:xfrm>
            <a:off x="5771979" y="2017215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A350ECF-ED37-4D0A-BDDD-DDD433273F89}"/>
              </a:ext>
            </a:extLst>
          </p:cNvPr>
          <p:cNvSpPr txBox="1"/>
          <p:nvPr/>
        </p:nvSpPr>
        <p:spPr>
          <a:xfrm>
            <a:off x="5622552" y="1613885"/>
            <a:ext cx="9074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C526355-4CD1-493E-8F7A-E3F8617A062A}"/>
              </a:ext>
            </a:extLst>
          </p:cNvPr>
          <p:cNvSpPr txBox="1"/>
          <p:nvPr/>
        </p:nvSpPr>
        <p:spPr>
          <a:xfrm>
            <a:off x="5771979" y="1853700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F7F1E4A-7F7D-46B5-BF8E-AB7FC7EA54BA}"/>
              </a:ext>
            </a:extLst>
          </p:cNvPr>
          <p:cNvSpPr txBox="1"/>
          <p:nvPr/>
        </p:nvSpPr>
        <p:spPr>
          <a:xfrm>
            <a:off x="5771979" y="2242003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F17A15C-1779-4B65-AC86-0DBE04971B47}"/>
              </a:ext>
            </a:extLst>
          </p:cNvPr>
          <p:cNvSpPr txBox="1"/>
          <p:nvPr/>
        </p:nvSpPr>
        <p:spPr>
          <a:xfrm>
            <a:off x="5771979" y="2371598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D2BFC971-C9C6-44C2-8E8B-3E56B1C65843}"/>
              </a:ext>
            </a:extLst>
          </p:cNvPr>
          <p:cNvCxnSpPr>
            <a:cxnSpLocks/>
          </p:cNvCxnSpPr>
          <p:nvPr/>
        </p:nvCxnSpPr>
        <p:spPr>
          <a:xfrm>
            <a:off x="6505727" y="2608087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CE0BE5B6-67F4-487C-8A35-F60031C9AFA5}"/>
              </a:ext>
            </a:extLst>
          </p:cNvPr>
          <p:cNvSpPr txBox="1"/>
          <p:nvPr/>
        </p:nvSpPr>
        <p:spPr>
          <a:xfrm>
            <a:off x="5771971" y="2533524"/>
            <a:ext cx="758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graphicFrame>
        <p:nvGraphicFramePr>
          <p:cNvPr id="107" name="표 41">
            <a:extLst>
              <a:ext uri="{FF2B5EF4-FFF2-40B4-BE49-F238E27FC236}">
                <a16:creationId xmlns:a16="http://schemas.microsoft.com/office/drawing/2014/main" id="{1EA1B6BA-D3D8-48C1-950D-C81F56AB1323}"/>
              </a:ext>
            </a:extLst>
          </p:cNvPr>
          <p:cNvGraphicFramePr>
            <a:graphicFrameLocks noGrp="1"/>
          </p:cNvGraphicFramePr>
          <p:nvPr/>
        </p:nvGraphicFramePr>
        <p:xfrm>
          <a:off x="2293136" y="2860791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pic>
        <p:nvPicPr>
          <p:cNvPr id="85" name="Picture 84">
            <a:extLst>
              <a:ext uri="{FF2B5EF4-FFF2-40B4-BE49-F238E27FC236}">
                <a16:creationId xmlns:a16="http://schemas.microsoft.com/office/drawing/2014/main" id="{D5EDD8ED-C87C-42B0-B8C2-04AA9AE37B74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04" t="29018" r="20121" b="30588"/>
          <a:stretch/>
        </p:blipFill>
        <p:spPr>
          <a:xfrm>
            <a:off x="8885542" y="957097"/>
            <a:ext cx="2147861" cy="1918266"/>
          </a:xfrm>
          <a:prstGeom prst="rect">
            <a:avLst/>
          </a:prstGeom>
        </p:spPr>
      </p:pic>
      <p:graphicFrame>
        <p:nvGraphicFramePr>
          <p:cNvPr id="108" name="표 41">
            <a:extLst>
              <a:ext uri="{FF2B5EF4-FFF2-40B4-BE49-F238E27FC236}">
                <a16:creationId xmlns:a16="http://schemas.microsoft.com/office/drawing/2014/main" id="{93989D19-B425-4036-8DD5-E04C9788E98D}"/>
              </a:ext>
            </a:extLst>
          </p:cNvPr>
          <p:cNvGraphicFramePr>
            <a:graphicFrameLocks noGrp="1"/>
          </p:cNvGraphicFramePr>
          <p:nvPr/>
        </p:nvGraphicFramePr>
        <p:xfrm>
          <a:off x="7705219" y="2860791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sp>
        <p:nvSpPr>
          <p:cNvPr id="47" name="TextBox 46">
            <a:extLst>
              <a:ext uri="{FF2B5EF4-FFF2-40B4-BE49-F238E27FC236}">
                <a16:creationId xmlns:a16="http://schemas.microsoft.com/office/drawing/2014/main" id="{D5CB2401-1248-46D4-8D15-5C5E2894FA1C}"/>
              </a:ext>
            </a:extLst>
          </p:cNvPr>
          <p:cNvSpPr txBox="1"/>
          <p:nvPr/>
        </p:nvSpPr>
        <p:spPr>
          <a:xfrm>
            <a:off x="9032755" y="1091521"/>
            <a:ext cx="20006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p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S235/236-S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ribosomal prote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9" name="표 41">
            <a:extLst>
              <a:ext uri="{FF2B5EF4-FFF2-40B4-BE49-F238E27FC236}">
                <a16:creationId xmlns:a16="http://schemas.microsoft.com/office/drawing/2014/main" id="{D00186AE-8074-4694-80DE-4910037EC3D6}"/>
              </a:ext>
            </a:extLst>
          </p:cNvPr>
          <p:cNvGraphicFramePr>
            <a:graphicFrameLocks noGrp="1"/>
          </p:cNvGraphicFramePr>
          <p:nvPr/>
        </p:nvGraphicFramePr>
        <p:xfrm>
          <a:off x="8176555" y="5760116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graphicFrame>
        <p:nvGraphicFramePr>
          <p:cNvPr id="110" name="표 41">
            <a:extLst>
              <a:ext uri="{FF2B5EF4-FFF2-40B4-BE49-F238E27FC236}">
                <a16:creationId xmlns:a16="http://schemas.microsoft.com/office/drawing/2014/main" id="{87A22FF9-FE84-4B05-BA60-42B80C1A01AA}"/>
              </a:ext>
            </a:extLst>
          </p:cNvPr>
          <p:cNvGraphicFramePr>
            <a:graphicFrameLocks noGrp="1"/>
          </p:cNvGraphicFramePr>
          <p:nvPr/>
        </p:nvGraphicFramePr>
        <p:xfrm>
          <a:off x="2403111" y="5760116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sp>
        <p:nvSpPr>
          <p:cNvPr id="111" name="Rectangle 110">
            <a:extLst>
              <a:ext uri="{FF2B5EF4-FFF2-40B4-BE49-F238E27FC236}">
                <a16:creationId xmlns:a16="http://schemas.microsoft.com/office/drawing/2014/main" id="{CD11DAA4-797F-4B5F-8EF1-9F89C8E22729}"/>
              </a:ext>
            </a:extLst>
          </p:cNvPr>
          <p:cNvSpPr/>
          <p:nvPr/>
        </p:nvSpPr>
        <p:spPr>
          <a:xfrm>
            <a:off x="3573302" y="1872381"/>
            <a:ext cx="1903861" cy="48778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64C88D09-9EFA-4A69-B281-2F00721A4943}"/>
              </a:ext>
            </a:extLst>
          </p:cNvPr>
          <p:cNvSpPr/>
          <p:nvPr/>
        </p:nvSpPr>
        <p:spPr>
          <a:xfrm>
            <a:off x="9439706" y="4705443"/>
            <a:ext cx="1953988" cy="48778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47238ED5-1D60-43E1-97A5-12CBC857DE3A}"/>
              </a:ext>
            </a:extLst>
          </p:cNvPr>
          <p:cNvSpPr/>
          <p:nvPr/>
        </p:nvSpPr>
        <p:spPr>
          <a:xfrm>
            <a:off x="3673177" y="4809705"/>
            <a:ext cx="1976421" cy="48778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E270FACF-477B-4564-87F2-DC8800D11541}"/>
              </a:ext>
            </a:extLst>
          </p:cNvPr>
          <p:cNvSpPr/>
          <p:nvPr/>
        </p:nvSpPr>
        <p:spPr>
          <a:xfrm>
            <a:off x="8975771" y="1933287"/>
            <a:ext cx="2000648" cy="48778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C4499BA-684B-4012-9D69-23DF43B50CBB}"/>
              </a:ext>
            </a:extLst>
          </p:cNvPr>
          <p:cNvSpPr txBox="1"/>
          <p:nvPr/>
        </p:nvSpPr>
        <p:spPr>
          <a:xfrm>
            <a:off x="620555" y="241293"/>
            <a:ext cx="110904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14: </a:t>
            </a:r>
            <a:r>
              <a:rPr lang="en-US" sz="1400" dirty="0"/>
              <a:t> Original images for the Western blot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F7 cells deprived of estrogen were treated with 5</a:t>
            </a:r>
            <a:r>
              <a:rPr lang="el-GR" sz="14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nd 10</a:t>
            </a:r>
            <a:r>
              <a:rPr lang="el-GR" sz="14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concentrations of compoun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ompoun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B + E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fter 24 hours the cell lysates were probed wit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pS6 antibodies for S235/236 and S240/244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79001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Picture 105">
            <a:extLst>
              <a:ext uri="{FF2B5EF4-FFF2-40B4-BE49-F238E27FC236}">
                <a16:creationId xmlns:a16="http://schemas.microsoft.com/office/drawing/2014/main" id="{E091B234-A12B-430E-8D17-C9618A5C4A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864" t="13172" r="22263" b="32245"/>
          <a:stretch/>
        </p:blipFill>
        <p:spPr>
          <a:xfrm>
            <a:off x="3230069" y="3814329"/>
            <a:ext cx="1986552" cy="1821998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A1DB1007-5FD1-4B35-A491-E0B70CA2688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231" t="27644" r="16007" b="31898"/>
          <a:stretch/>
        </p:blipFill>
        <p:spPr>
          <a:xfrm>
            <a:off x="1161834" y="856976"/>
            <a:ext cx="2132285" cy="1883009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F428FE35-2D06-45C5-9722-672797EBE57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00" t="27644" r="15586" b="32412"/>
          <a:stretch/>
        </p:blipFill>
        <p:spPr>
          <a:xfrm>
            <a:off x="3328845" y="849975"/>
            <a:ext cx="1966347" cy="189001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5B4FD051-8D5B-4A12-8936-90CE5F9B54F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865" t="16190" r="23682" b="43852"/>
          <a:stretch/>
        </p:blipFill>
        <p:spPr>
          <a:xfrm>
            <a:off x="9034074" y="3923125"/>
            <a:ext cx="1986552" cy="1821998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2A066A76-008D-4F1D-8DDF-F885E07FD1D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08" t="16500" r="22142" b="43542"/>
          <a:stretch/>
        </p:blipFill>
        <p:spPr>
          <a:xfrm>
            <a:off x="6816836" y="3926684"/>
            <a:ext cx="2161137" cy="1821998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A5DA19FF-58C0-4045-BA6D-501AE68A0C6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17" t="23142" r="20240" b="37711"/>
          <a:stretch/>
        </p:blipFill>
        <p:spPr>
          <a:xfrm>
            <a:off x="1146327" y="3814328"/>
            <a:ext cx="2035049" cy="182199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E618C51-FD96-4630-A07D-4FEC62FD2628}"/>
              </a:ext>
            </a:extLst>
          </p:cNvPr>
          <p:cNvSpPr txBox="1"/>
          <p:nvPr/>
        </p:nvSpPr>
        <p:spPr>
          <a:xfrm>
            <a:off x="3299904" y="4243069"/>
            <a:ext cx="19001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t-S6 ribosomal prote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D79AF3C-CCFA-42AC-BC3B-0E64694D8593}"/>
              </a:ext>
            </a:extLst>
          </p:cNvPr>
          <p:cNvCxnSpPr>
            <a:cxnSpLocks/>
          </p:cNvCxnSpPr>
          <p:nvPr/>
        </p:nvCxnSpPr>
        <p:spPr>
          <a:xfrm>
            <a:off x="1053344" y="3949829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05696AB-D982-4C65-B457-B907FEC0CFE9}"/>
              </a:ext>
            </a:extLst>
          </p:cNvPr>
          <p:cNvCxnSpPr>
            <a:cxnSpLocks/>
          </p:cNvCxnSpPr>
          <p:nvPr/>
        </p:nvCxnSpPr>
        <p:spPr>
          <a:xfrm>
            <a:off x="1053344" y="4143433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519E007-7D4A-4D9C-A03A-6EB309B507DF}"/>
              </a:ext>
            </a:extLst>
          </p:cNvPr>
          <p:cNvCxnSpPr>
            <a:cxnSpLocks/>
          </p:cNvCxnSpPr>
          <p:nvPr/>
        </p:nvCxnSpPr>
        <p:spPr>
          <a:xfrm>
            <a:off x="1053344" y="4316588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5B194E6-F8CD-447A-B70B-5F30C544CAD6}"/>
              </a:ext>
            </a:extLst>
          </p:cNvPr>
          <p:cNvCxnSpPr>
            <a:cxnSpLocks/>
          </p:cNvCxnSpPr>
          <p:nvPr/>
        </p:nvCxnSpPr>
        <p:spPr>
          <a:xfrm>
            <a:off x="1053344" y="4637270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111DE11C-0532-4225-8557-C13883AF949A}"/>
              </a:ext>
            </a:extLst>
          </p:cNvPr>
          <p:cNvCxnSpPr>
            <a:cxnSpLocks/>
          </p:cNvCxnSpPr>
          <p:nvPr/>
        </p:nvCxnSpPr>
        <p:spPr>
          <a:xfrm>
            <a:off x="1053344" y="4797609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DEAFA89-5F56-4BF1-8818-0EE608F0E190}"/>
              </a:ext>
            </a:extLst>
          </p:cNvPr>
          <p:cNvCxnSpPr>
            <a:cxnSpLocks/>
          </p:cNvCxnSpPr>
          <p:nvPr/>
        </p:nvCxnSpPr>
        <p:spPr>
          <a:xfrm>
            <a:off x="1053344" y="5024574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8FA375A-4D4A-4CAD-885A-1F87A2AE7441}"/>
              </a:ext>
            </a:extLst>
          </p:cNvPr>
          <p:cNvCxnSpPr>
            <a:cxnSpLocks/>
          </p:cNvCxnSpPr>
          <p:nvPr/>
        </p:nvCxnSpPr>
        <p:spPr>
          <a:xfrm>
            <a:off x="1053344" y="5111492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759DAD7-9687-4D2C-94E1-0382E6F0F8EA}"/>
              </a:ext>
            </a:extLst>
          </p:cNvPr>
          <p:cNvCxnSpPr>
            <a:cxnSpLocks/>
          </p:cNvCxnSpPr>
          <p:nvPr/>
        </p:nvCxnSpPr>
        <p:spPr>
          <a:xfrm>
            <a:off x="1053344" y="4431483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4CE882B-704A-4EE6-8F3B-C919107E91BD}"/>
              </a:ext>
            </a:extLst>
          </p:cNvPr>
          <p:cNvSpPr txBox="1"/>
          <p:nvPr/>
        </p:nvSpPr>
        <p:spPr>
          <a:xfrm>
            <a:off x="159009" y="943252"/>
            <a:ext cx="8920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DA1C633-B4C4-4FD6-A83B-3750F26EC86B}"/>
              </a:ext>
            </a:extLst>
          </p:cNvPr>
          <p:cNvSpPr txBox="1"/>
          <p:nvPr/>
        </p:nvSpPr>
        <p:spPr>
          <a:xfrm>
            <a:off x="261262" y="4048150"/>
            <a:ext cx="8163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F1AE25-C9D1-4F3D-A155-806BB6058F42}"/>
              </a:ext>
            </a:extLst>
          </p:cNvPr>
          <p:cNvSpPr txBox="1"/>
          <p:nvPr/>
        </p:nvSpPr>
        <p:spPr>
          <a:xfrm>
            <a:off x="203354" y="4215746"/>
            <a:ext cx="8742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9613A5D-F5D4-4F01-BA23-AF5AFDBE16F1}"/>
              </a:ext>
            </a:extLst>
          </p:cNvPr>
          <p:cNvSpPr txBox="1"/>
          <p:nvPr/>
        </p:nvSpPr>
        <p:spPr>
          <a:xfrm>
            <a:off x="370082" y="4703912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E0B1867-11BB-4211-8AEE-0702A806633F}"/>
              </a:ext>
            </a:extLst>
          </p:cNvPr>
          <p:cNvSpPr txBox="1"/>
          <p:nvPr/>
        </p:nvSpPr>
        <p:spPr>
          <a:xfrm>
            <a:off x="230608" y="4332415"/>
            <a:ext cx="8469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0593D8C-AA1F-4008-A7DB-8C162CC53604}"/>
              </a:ext>
            </a:extLst>
          </p:cNvPr>
          <p:cNvSpPr txBox="1"/>
          <p:nvPr/>
        </p:nvSpPr>
        <p:spPr>
          <a:xfrm>
            <a:off x="370082" y="4540397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232075A-6399-45CF-BA56-B8923AEF2085}"/>
              </a:ext>
            </a:extLst>
          </p:cNvPr>
          <p:cNvSpPr txBox="1"/>
          <p:nvPr/>
        </p:nvSpPr>
        <p:spPr>
          <a:xfrm>
            <a:off x="370082" y="4912074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404AFA5-90C9-406D-B67E-647945500A73}"/>
              </a:ext>
            </a:extLst>
          </p:cNvPr>
          <p:cNvSpPr txBox="1"/>
          <p:nvPr/>
        </p:nvSpPr>
        <p:spPr>
          <a:xfrm>
            <a:off x="370082" y="5022577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2C092318-52F0-491A-984A-5F63512CA14C}"/>
              </a:ext>
            </a:extLst>
          </p:cNvPr>
          <p:cNvCxnSpPr>
            <a:cxnSpLocks/>
          </p:cNvCxnSpPr>
          <p:nvPr/>
        </p:nvCxnSpPr>
        <p:spPr>
          <a:xfrm>
            <a:off x="1053336" y="5273418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1D836E-BE3E-4DF1-93D0-D30DDCD9B63B}"/>
              </a:ext>
            </a:extLst>
          </p:cNvPr>
          <p:cNvSpPr txBox="1"/>
          <p:nvPr/>
        </p:nvSpPr>
        <p:spPr>
          <a:xfrm>
            <a:off x="370074" y="5184503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1122176-DA09-4F58-8990-763BE97ED620}"/>
              </a:ext>
            </a:extLst>
          </p:cNvPr>
          <p:cNvCxnSpPr>
            <a:cxnSpLocks/>
          </p:cNvCxnSpPr>
          <p:nvPr/>
        </p:nvCxnSpPr>
        <p:spPr>
          <a:xfrm>
            <a:off x="1051086" y="1237530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9DCCA32C-F23E-49E4-B696-4462AD95C89A}"/>
              </a:ext>
            </a:extLst>
          </p:cNvPr>
          <p:cNvCxnSpPr>
            <a:cxnSpLocks/>
          </p:cNvCxnSpPr>
          <p:nvPr/>
        </p:nvCxnSpPr>
        <p:spPr>
          <a:xfrm>
            <a:off x="1051086" y="1429737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A943AD5-65B5-489F-9B0B-9639D59D8CAB}"/>
              </a:ext>
            </a:extLst>
          </p:cNvPr>
          <p:cNvCxnSpPr>
            <a:cxnSpLocks/>
          </p:cNvCxnSpPr>
          <p:nvPr/>
        </p:nvCxnSpPr>
        <p:spPr>
          <a:xfrm>
            <a:off x="1051086" y="1750419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1B61F967-D767-44F8-BC86-1C8627385776}"/>
              </a:ext>
            </a:extLst>
          </p:cNvPr>
          <p:cNvCxnSpPr>
            <a:cxnSpLocks/>
          </p:cNvCxnSpPr>
          <p:nvPr/>
        </p:nvCxnSpPr>
        <p:spPr>
          <a:xfrm>
            <a:off x="1051086" y="1910758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3A5C36B-326D-4E68-8915-B8614FF7EF37}"/>
              </a:ext>
            </a:extLst>
          </p:cNvPr>
          <p:cNvCxnSpPr>
            <a:cxnSpLocks/>
          </p:cNvCxnSpPr>
          <p:nvPr/>
        </p:nvCxnSpPr>
        <p:spPr>
          <a:xfrm>
            <a:off x="1051086" y="2147247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5F5A9083-461E-4568-80C7-7A521C0F435D}"/>
              </a:ext>
            </a:extLst>
          </p:cNvPr>
          <p:cNvCxnSpPr>
            <a:cxnSpLocks/>
          </p:cNvCxnSpPr>
          <p:nvPr/>
        </p:nvCxnSpPr>
        <p:spPr>
          <a:xfrm>
            <a:off x="1051086" y="2260359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B5E88491-63A3-44C2-A965-2950AB4376B9}"/>
              </a:ext>
            </a:extLst>
          </p:cNvPr>
          <p:cNvCxnSpPr>
            <a:cxnSpLocks/>
          </p:cNvCxnSpPr>
          <p:nvPr/>
        </p:nvCxnSpPr>
        <p:spPr>
          <a:xfrm>
            <a:off x="1051086" y="1544632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7E99F787-8ABE-4BAA-89F6-53DAAE9F525A}"/>
              </a:ext>
            </a:extLst>
          </p:cNvPr>
          <p:cNvSpPr txBox="1"/>
          <p:nvPr/>
        </p:nvSpPr>
        <p:spPr>
          <a:xfrm>
            <a:off x="259004" y="1142247"/>
            <a:ext cx="8163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B7854C6-8CB7-4B69-81F1-74EB82F9B109}"/>
              </a:ext>
            </a:extLst>
          </p:cNvPr>
          <p:cNvSpPr txBox="1"/>
          <p:nvPr/>
        </p:nvSpPr>
        <p:spPr>
          <a:xfrm>
            <a:off x="201096" y="1328895"/>
            <a:ext cx="8742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7B70247-404E-4730-9B25-C1598062437B}"/>
              </a:ext>
            </a:extLst>
          </p:cNvPr>
          <p:cNvSpPr txBox="1"/>
          <p:nvPr/>
        </p:nvSpPr>
        <p:spPr>
          <a:xfrm>
            <a:off x="367824" y="1817061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CA4FDC5-6C94-4E8A-99BE-78E365FF1F88}"/>
              </a:ext>
            </a:extLst>
          </p:cNvPr>
          <p:cNvSpPr txBox="1"/>
          <p:nvPr/>
        </p:nvSpPr>
        <p:spPr>
          <a:xfrm>
            <a:off x="228350" y="1445564"/>
            <a:ext cx="8469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4F78891-005C-4412-8096-BF1AE08E0CE6}"/>
              </a:ext>
            </a:extLst>
          </p:cNvPr>
          <p:cNvSpPr txBox="1"/>
          <p:nvPr/>
        </p:nvSpPr>
        <p:spPr>
          <a:xfrm>
            <a:off x="367824" y="1653546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FD8BF0F-171F-47F1-8CD0-7F65D3C12CED}"/>
              </a:ext>
            </a:extLst>
          </p:cNvPr>
          <p:cNvSpPr txBox="1"/>
          <p:nvPr/>
        </p:nvSpPr>
        <p:spPr>
          <a:xfrm>
            <a:off x="367824" y="2041849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80F2830-1017-4647-8DC1-0021A2513417}"/>
              </a:ext>
            </a:extLst>
          </p:cNvPr>
          <p:cNvSpPr txBox="1"/>
          <p:nvPr/>
        </p:nvSpPr>
        <p:spPr>
          <a:xfrm>
            <a:off x="367824" y="2171444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A9C464AD-E68D-4FC0-A6A7-EA68E01A7C00}"/>
              </a:ext>
            </a:extLst>
          </p:cNvPr>
          <p:cNvCxnSpPr>
            <a:cxnSpLocks/>
          </p:cNvCxnSpPr>
          <p:nvPr/>
        </p:nvCxnSpPr>
        <p:spPr>
          <a:xfrm>
            <a:off x="1051078" y="2422285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F6D63826-BA03-4D5F-9173-0397B7E5E1C3}"/>
              </a:ext>
            </a:extLst>
          </p:cNvPr>
          <p:cNvSpPr txBox="1"/>
          <p:nvPr/>
        </p:nvSpPr>
        <p:spPr>
          <a:xfrm>
            <a:off x="367816" y="2333370"/>
            <a:ext cx="707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B56BCAA-E593-419A-B9F4-42D0D47E84DA}"/>
              </a:ext>
            </a:extLst>
          </p:cNvPr>
          <p:cNvSpPr txBox="1"/>
          <p:nvPr/>
        </p:nvSpPr>
        <p:spPr>
          <a:xfrm>
            <a:off x="192489" y="3849711"/>
            <a:ext cx="8920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55BBFD5-6357-4A9E-A5DC-EFB132E6EEE8}"/>
              </a:ext>
            </a:extLst>
          </p:cNvPr>
          <p:cNvSpPr txBox="1"/>
          <p:nvPr/>
        </p:nvSpPr>
        <p:spPr>
          <a:xfrm>
            <a:off x="3278539" y="908829"/>
            <a:ext cx="2311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p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S240/244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-S6 ribosomal prote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80288164-936B-44FA-84A0-0E563B07BB66}"/>
              </a:ext>
            </a:extLst>
          </p:cNvPr>
          <p:cNvCxnSpPr>
            <a:cxnSpLocks/>
          </p:cNvCxnSpPr>
          <p:nvPr/>
        </p:nvCxnSpPr>
        <p:spPr>
          <a:xfrm>
            <a:off x="6721172" y="4052469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BFE35C12-BF74-4ED0-9EC6-CDDAD2E62F3A}"/>
              </a:ext>
            </a:extLst>
          </p:cNvPr>
          <p:cNvCxnSpPr>
            <a:cxnSpLocks/>
          </p:cNvCxnSpPr>
          <p:nvPr/>
        </p:nvCxnSpPr>
        <p:spPr>
          <a:xfrm>
            <a:off x="6721172" y="4236546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32B700FB-C915-4140-B944-5A515F25B1E8}"/>
              </a:ext>
            </a:extLst>
          </p:cNvPr>
          <p:cNvCxnSpPr>
            <a:cxnSpLocks/>
          </p:cNvCxnSpPr>
          <p:nvPr/>
        </p:nvCxnSpPr>
        <p:spPr>
          <a:xfrm>
            <a:off x="6721172" y="4409701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ECAD2F4F-FF07-4ACD-8BF3-CE5E2214748D}"/>
              </a:ext>
            </a:extLst>
          </p:cNvPr>
          <p:cNvCxnSpPr>
            <a:cxnSpLocks/>
          </p:cNvCxnSpPr>
          <p:nvPr/>
        </p:nvCxnSpPr>
        <p:spPr>
          <a:xfrm>
            <a:off x="6721172" y="4739907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A6FD6722-2823-44F5-B5DC-F7FAC9D62EED}"/>
              </a:ext>
            </a:extLst>
          </p:cNvPr>
          <p:cNvCxnSpPr>
            <a:cxnSpLocks/>
          </p:cNvCxnSpPr>
          <p:nvPr/>
        </p:nvCxnSpPr>
        <p:spPr>
          <a:xfrm>
            <a:off x="6721172" y="4900246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D340128-188A-478F-91D7-2BEE38715F75}"/>
              </a:ext>
            </a:extLst>
          </p:cNvPr>
          <p:cNvCxnSpPr>
            <a:cxnSpLocks/>
          </p:cNvCxnSpPr>
          <p:nvPr/>
        </p:nvCxnSpPr>
        <p:spPr>
          <a:xfrm>
            <a:off x="6721172" y="5127211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D5BF1070-8BF1-49AF-B47E-AF8FF3529ECE}"/>
              </a:ext>
            </a:extLst>
          </p:cNvPr>
          <p:cNvCxnSpPr>
            <a:cxnSpLocks/>
          </p:cNvCxnSpPr>
          <p:nvPr/>
        </p:nvCxnSpPr>
        <p:spPr>
          <a:xfrm>
            <a:off x="6721172" y="5214129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366EAD4D-3CB3-495A-998B-48AB09F7DD7A}"/>
              </a:ext>
            </a:extLst>
          </p:cNvPr>
          <p:cNvCxnSpPr>
            <a:cxnSpLocks/>
          </p:cNvCxnSpPr>
          <p:nvPr/>
        </p:nvCxnSpPr>
        <p:spPr>
          <a:xfrm>
            <a:off x="6721172" y="4534120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C5586B00-4611-49A9-ACE6-DCC37B324885}"/>
              </a:ext>
            </a:extLst>
          </p:cNvPr>
          <p:cNvSpPr txBox="1"/>
          <p:nvPr/>
        </p:nvSpPr>
        <p:spPr>
          <a:xfrm>
            <a:off x="5882238" y="4141262"/>
            <a:ext cx="8631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B2C56FF-3ECE-48B8-A777-DE5BF248E4EC}"/>
              </a:ext>
            </a:extLst>
          </p:cNvPr>
          <p:cNvSpPr txBox="1"/>
          <p:nvPr/>
        </p:nvSpPr>
        <p:spPr>
          <a:xfrm>
            <a:off x="5821006" y="4308858"/>
            <a:ext cx="9244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A8B1B4C-DE6B-4F28-9EBA-453FF926CDCE}"/>
              </a:ext>
            </a:extLst>
          </p:cNvPr>
          <p:cNvSpPr txBox="1"/>
          <p:nvPr/>
        </p:nvSpPr>
        <p:spPr>
          <a:xfrm>
            <a:off x="5997304" y="4806548"/>
            <a:ext cx="7481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9FD8D14-0D09-437F-92D8-20B9FC4690B1}"/>
              </a:ext>
            </a:extLst>
          </p:cNvPr>
          <p:cNvSpPr txBox="1"/>
          <p:nvPr/>
        </p:nvSpPr>
        <p:spPr>
          <a:xfrm>
            <a:off x="5849826" y="4435051"/>
            <a:ext cx="8955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4DAF262-7FCD-4125-B651-852F4F7E048B}"/>
              </a:ext>
            </a:extLst>
          </p:cNvPr>
          <p:cNvSpPr txBox="1"/>
          <p:nvPr/>
        </p:nvSpPr>
        <p:spPr>
          <a:xfrm>
            <a:off x="5997304" y="4643033"/>
            <a:ext cx="7481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62C8BF6-8E18-4D02-ABD6-10C317DAB97B}"/>
              </a:ext>
            </a:extLst>
          </p:cNvPr>
          <p:cNvSpPr txBox="1"/>
          <p:nvPr/>
        </p:nvSpPr>
        <p:spPr>
          <a:xfrm>
            <a:off x="5997304" y="5014710"/>
            <a:ext cx="7481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27BD00D-3C7C-440F-9FA0-0476A6995922}"/>
              </a:ext>
            </a:extLst>
          </p:cNvPr>
          <p:cNvSpPr txBox="1"/>
          <p:nvPr/>
        </p:nvSpPr>
        <p:spPr>
          <a:xfrm>
            <a:off x="5997304" y="5125213"/>
            <a:ext cx="7481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EAE7B268-CD3C-4170-A84B-F578A31F08FE}"/>
              </a:ext>
            </a:extLst>
          </p:cNvPr>
          <p:cNvCxnSpPr>
            <a:cxnSpLocks/>
          </p:cNvCxnSpPr>
          <p:nvPr/>
        </p:nvCxnSpPr>
        <p:spPr>
          <a:xfrm>
            <a:off x="6721164" y="5376055"/>
            <a:ext cx="95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AC503A93-284A-482A-BC7B-FBF932A364ED}"/>
              </a:ext>
            </a:extLst>
          </p:cNvPr>
          <p:cNvSpPr txBox="1"/>
          <p:nvPr/>
        </p:nvSpPr>
        <p:spPr>
          <a:xfrm>
            <a:off x="5997296" y="5287139"/>
            <a:ext cx="7481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0D02F65-2B6E-4C7A-B60A-83513230BE61}"/>
              </a:ext>
            </a:extLst>
          </p:cNvPr>
          <p:cNvSpPr txBox="1"/>
          <p:nvPr/>
        </p:nvSpPr>
        <p:spPr>
          <a:xfrm>
            <a:off x="5809117" y="3952350"/>
            <a:ext cx="9432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68D55F1-E930-4085-B2F9-D5015F0ABD3D}"/>
              </a:ext>
            </a:extLst>
          </p:cNvPr>
          <p:cNvSpPr txBox="1"/>
          <p:nvPr/>
        </p:nvSpPr>
        <p:spPr>
          <a:xfrm>
            <a:off x="9494838" y="4012124"/>
            <a:ext cx="1156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GADPH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F288A3A-0F55-4BF9-B184-6AD2569FDB72}"/>
              </a:ext>
            </a:extLst>
          </p:cNvPr>
          <p:cNvSpPr txBox="1"/>
          <p:nvPr/>
        </p:nvSpPr>
        <p:spPr>
          <a:xfrm>
            <a:off x="5924767" y="813807"/>
            <a:ext cx="8920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629DFFB-D022-4805-8058-97849E65F59D}"/>
              </a:ext>
            </a:extLst>
          </p:cNvPr>
          <p:cNvSpPr txBox="1"/>
          <p:nvPr/>
        </p:nvSpPr>
        <p:spPr>
          <a:xfrm>
            <a:off x="5942599" y="1167698"/>
            <a:ext cx="8742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A350ECF-ED37-4D0A-BDDD-DDD433273F89}"/>
              </a:ext>
            </a:extLst>
          </p:cNvPr>
          <p:cNvSpPr txBox="1"/>
          <p:nvPr/>
        </p:nvSpPr>
        <p:spPr>
          <a:xfrm>
            <a:off x="5969853" y="1284367"/>
            <a:ext cx="8469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5B764631-7FB9-4FBB-8686-0FD56FF6A477}"/>
              </a:ext>
            </a:extLst>
          </p:cNvPr>
          <p:cNvSpPr txBox="1"/>
          <p:nvPr/>
        </p:nvSpPr>
        <p:spPr>
          <a:xfrm>
            <a:off x="533112" y="223947"/>
            <a:ext cx="109598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15: </a:t>
            </a:r>
            <a:r>
              <a:rPr lang="en-US" sz="1400" dirty="0"/>
              <a:t>Original images for the Western blot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F7 cells deprived of estrogen were treated with 5</a:t>
            </a:r>
            <a:r>
              <a:rPr lang="el-GR" sz="14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nd 10</a:t>
            </a:r>
            <a:r>
              <a:rPr lang="el-GR" sz="14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concentrations of compoun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ompoun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B + E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fter 48 hours the cell lysates were probed wit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pS6 antibodies for S235/236 and S240/244.</a:t>
            </a:r>
            <a:r>
              <a:rPr lang="en-US" sz="1400" dirty="0"/>
              <a:t> </a:t>
            </a:r>
          </a:p>
        </p:txBody>
      </p:sp>
      <p:graphicFrame>
        <p:nvGraphicFramePr>
          <p:cNvPr id="108" name="표 41">
            <a:extLst>
              <a:ext uri="{FF2B5EF4-FFF2-40B4-BE49-F238E27FC236}">
                <a16:creationId xmlns:a16="http://schemas.microsoft.com/office/drawing/2014/main" id="{5734E8EA-F47C-4A9B-9279-DBDBC4D6C45F}"/>
              </a:ext>
            </a:extLst>
          </p:cNvPr>
          <p:cNvGraphicFramePr>
            <a:graphicFrameLocks noGrp="1"/>
          </p:cNvGraphicFramePr>
          <p:nvPr/>
        </p:nvGraphicFramePr>
        <p:xfrm>
          <a:off x="2105592" y="2777051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sp>
        <p:nvSpPr>
          <p:cNvPr id="109" name="Rectangle 108">
            <a:extLst>
              <a:ext uri="{FF2B5EF4-FFF2-40B4-BE49-F238E27FC236}">
                <a16:creationId xmlns:a16="http://schemas.microsoft.com/office/drawing/2014/main" id="{E06BB721-D028-4099-92F8-80472278C5C8}"/>
              </a:ext>
            </a:extLst>
          </p:cNvPr>
          <p:cNvSpPr/>
          <p:nvPr/>
        </p:nvSpPr>
        <p:spPr>
          <a:xfrm>
            <a:off x="3330923" y="1743594"/>
            <a:ext cx="1976421" cy="48778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10" name="표 41">
            <a:extLst>
              <a:ext uri="{FF2B5EF4-FFF2-40B4-BE49-F238E27FC236}">
                <a16:creationId xmlns:a16="http://schemas.microsoft.com/office/drawing/2014/main" id="{AE834AA1-177F-42A1-827A-4FFD12D63EC6}"/>
              </a:ext>
            </a:extLst>
          </p:cNvPr>
          <p:cNvGraphicFramePr>
            <a:graphicFrameLocks noGrp="1"/>
          </p:cNvGraphicFramePr>
          <p:nvPr/>
        </p:nvGraphicFramePr>
        <p:xfrm>
          <a:off x="2010455" y="5709755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sp>
        <p:nvSpPr>
          <p:cNvPr id="111" name="Rectangle 110">
            <a:extLst>
              <a:ext uri="{FF2B5EF4-FFF2-40B4-BE49-F238E27FC236}">
                <a16:creationId xmlns:a16="http://schemas.microsoft.com/office/drawing/2014/main" id="{E522AFCA-5935-45E7-B397-8FE1B2C82074}"/>
              </a:ext>
            </a:extLst>
          </p:cNvPr>
          <p:cNvSpPr/>
          <p:nvPr/>
        </p:nvSpPr>
        <p:spPr>
          <a:xfrm>
            <a:off x="3235134" y="4679868"/>
            <a:ext cx="1976421" cy="48778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12" name="표 41">
            <a:extLst>
              <a:ext uri="{FF2B5EF4-FFF2-40B4-BE49-F238E27FC236}">
                <a16:creationId xmlns:a16="http://schemas.microsoft.com/office/drawing/2014/main" id="{6A011D8C-35A7-4121-8C90-AD12A71A52BE}"/>
              </a:ext>
            </a:extLst>
          </p:cNvPr>
          <p:cNvGraphicFramePr>
            <a:graphicFrameLocks noGrp="1"/>
          </p:cNvGraphicFramePr>
          <p:nvPr/>
        </p:nvGraphicFramePr>
        <p:xfrm>
          <a:off x="7839375" y="5709755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sp>
        <p:nvSpPr>
          <p:cNvPr id="113" name="Rectangle 112">
            <a:extLst>
              <a:ext uri="{FF2B5EF4-FFF2-40B4-BE49-F238E27FC236}">
                <a16:creationId xmlns:a16="http://schemas.microsoft.com/office/drawing/2014/main" id="{B0D886CF-0D92-4AD2-8BC7-7C842587475F}"/>
              </a:ext>
            </a:extLst>
          </p:cNvPr>
          <p:cNvSpPr/>
          <p:nvPr/>
        </p:nvSpPr>
        <p:spPr>
          <a:xfrm>
            <a:off x="9036356" y="4671202"/>
            <a:ext cx="1976421" cy="48778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14" name="표 41">
            <a:extLst>
              <a:ext uri="{FF2B5EF4-FFF2-40B4-BE49-F238E27FC236}">
                <a16:creationId xmlns:a16="http://schemas.microsoft.com/office/drawing/2014/main" id="{DB9510BB-662D-44B4-BF84-9F7F3FAE33DA}"/>
              </a:ext>
            </a:extLst>
          </p:cNvPr>
          <p:cNvGraphicFramePr>
            <a:graphicFrameLocks noGrp="1"/>
          </p:cNvGraphicFramePr>
          <p:nvPr/>
        </p:nvGraphicFramePr>
        <p:xfrm>
          <a:off x="7831026" y="2777051"/>
          <a:ext cx="3189600" cy="396623"/>
        </p:xfrm>
        <a:graphic>
          <a:graphicData uri="http://schemas.openxmlformats.org/drawingml/2006/table">
            <a:tbl>
              <a:tblPr/>
              <a:tblGrid>
                <a:gridCol w="1275840">
                  <a:extLst>
                    <a:ext uri="{9D8B030D-6E8A-4147-A177-3AD203B41FA5}">
                      <a16:colId xmlns:a16="http://schemas.microsoft.com/office/drawing/2014/main" val="2242011066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56890965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097326893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643386840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352210882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3050028418"/>
                    </a:ext>
                  </a:extLst>
                </a:gridCol>
                <a:gridCol w="318960">
                  <a:extLst>
                    <a:ext uri="{9D8B030D-6E8A-4147-A177-3AD203B41FA5}">
                      <a16:colId xmlns:a16="http://schemas.microsoft.com/office/drawing/2014/main" val="2411501083"/>
                    </a:ext>
                  </a:extLst>
                </a:gridCol>
              </a:tblGrid>
              <a:tr h="197939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+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8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</a:t>
                      </a:r>
                      <a:endParaRPr lang="ko-KR" altLang="ko-KR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100" b="0" kern="100" baseline="0" dirty="0"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</a:t>
                      </a:r>
                      <a:endParaRPr lang="ko-KR" altLang="en-US" sz="1100" b="0" kern="100" baseline="0" dirty="0"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81280" marR="812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76313"/>
                  </a:ext>
                </a:extLst>
              </a:tr>
            </a:tbl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6DE9F901-9661-4002-BC1D-8B7D9110239E}"/>
              </a:ext>
            </a:extLst>
          </p:cNvPr>
          <p:cNvGrpSpPr/>
          <p:nvPr/>
        </p:nvGrpSpPr>
        <p:grpSpPr>
          <a:xfrm>
            <a:off x="6000507" y="813806"/>
            <a:ext cx="5237570" cy="1914161"/>
            <a:chOff x="6000507" y="813807"/>
            <a:chExt cx="5237570" cy="1744438"/>
          </a:xfrm>
        </p:grpSpPr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B48DA552-C4DE-4511-B090-BD1C439BA3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076" t="29581" r="16374" b="32459"/>
            <a:stretch/>
          </p:blipFill>
          <p:spPr>
            <a:xfrm>
              <a:off x="9051768" y="813807"/>
              <a:ext cx="2043139" cy="1730855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C24552FE-1175-4AD0-A647-43A6A130EA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550" t="29716" r="17382" b="32271"/>
            <a:stretch/>
          </p:blipFill>
          <p:spPr>
            <a:xfrm>
              <a:off x="6896810" y="824938"/>
              <a:ext cx="2106855" cy="1733307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5CB2401-1248-46D4-8D15-5C5E2894FA1C}"/>
                </a:ext>
              </a:extLst>
            </p:cNvPr>
            <p:cNvSpPr txBox="1"/>
            <p:nvPr/>
          </p:nvSpPr>
          <p:spPr>
            <a:xfrm>
              <a:off x="9052010" y="862773"/>
              <a:ext cx="21860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p</a:t>
              </a:r>
              <a:r>
                <a:rPr lang="en-US" sz="11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S235/236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-S6 ribosomal protein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AD5348C7-55FD-4892-9021-F4C9E7A818EF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919242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F5AF641B-9CDD-4847-941C-303767006A8B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1112844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A7FEBDBC-BD8B-43A1-8FAD-09FD97CC8610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1278064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F89603BD-2CFE-47F9-9034-92486C8D6740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1613035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24F44920-8DFF-4FB8-9766-D80E8805A7D9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1773374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8892BC79-F312-4DC5-A578-A9E785C2E5CC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2009863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F01A643E-A804-4F56-AB2D-B8C2ACABE41F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2122975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B9A19479-1C39-420C-A10B-A075B0FD033F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9" y="1392959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A05EAFA4-4D80-4BF9-8B9B-0BC9DDCE0F12}"/>
                </a:ext>
              </a:extLst>
            </p:cNvPr>
            <p:cNvSpPr txBox="1"/>
            <p:nvPr/>
          </p:nvSpPr>
          <p:spPr>
            <a:xfrm>
              <a:off x="6000507" y="1008037"/>
              <a:ext cx="8163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kDa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4B37358-120D-43D1-BDFE-517138D9F62E}"/>
                </a:ext>
              </a:extLst>
            </p:cNvPr>
            <p:cNvSpPr txBox="1"/>
            <p:nvPr/>
          </p:nvSpPr>
          <p:spPr>
            <a:xfrm>
              <a:off x="6109327" y="1679677"/>
              <a:ext cx="7075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C526355-4CD1-493E-8F7A-E3F8617A062A}"/>
                </a:ext>
              </a:extLst>
            </p:cNvPr>
            <p:cNvSpPr txBox="1"/>
            <p:nvPr/>
          </p:nvSpPr>
          <p:spPr>
            <a:xfrm>
              <a:off x="6109327" y="1516162"/>
              <a:ext cx="7075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F7F1E4A-7F7D-46B5-BF8E-AB7FC7EA54BA}"/>
                </a:ext>
              </a:extLst>
            </p:cNvPr>
            <p:cNvSpPr txBox="1"/>
            <p:nvPr/>
          </p:nvSpPr>
          <p:spPr>
            <a:xfrm>
              <a:off x="6109327" y="1904465"/>
              <a:ext cx="707509" cy="238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kDa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CF17A15C-1779-4B65-AC86-0DBE04971B47}"/>
                </a:ext>
              </a:extLst>
            </p:cNvPr>
            <p:cNvSpPr txBox="1"/>
            <p:nvPr/>
          </p:nvSpPr>
          <p:spPr>
            <a:xfrm>
              <a:off x="6109327" y="2034060"/>
              <a:ext cx="7075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kDa</a:t>
              </a:r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D2BFC971-C9C6-44C2-8E8B-3E56B1C65843}"/>
                </a:ext>
              </a:extLst>
            </p:cNvPr>
            <p:cNvCxnSpPr>
              <a:cxnSpLocks/>
            </p:cNvCxnSpPr>
            <p:nvPr/>
          </p:nvCxnSpPr>
          <p:spPr>
            <a:xfrm>
              <a:off x="6792581" y="2284901"/>
              <a:ext cx="952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CE0BE5B6-67F4-487C-8A35-F60031C9AFA5}"/>
                </a:ext>
              </a:extLst>
            </p:cNvPr>
            <p:cNvSpPr txBox="1"/>
            <p:nvPr/>
          </p:nvSpPr>
          <p:spPr>
            <a:xfrm>
              <a:off x="6109327" y="2195986"/>
              <a:ext cx="7075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kDa</a:t>
              </a: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8688CA72-99A0-46D2-9EBE-D07A6DF3661D}"/>
                </a:ext>
              </a:extLst>
            </p:cNvPr>
            <p:cNvSpPr/>
            <p:nvPr/>
          </p:nvSpPr>
          <p:spPr>
            <a:xfrm>
              <a:off x="9085126" y="1595044"/>
              <a:ext cx="1976421" cy="48778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0136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CD9C0-BFF2-459C-8E88-8490473887CB}" type="slidenum">
              <a:rPr lang="en-US" smtClean="0"/>
              <a:t>2</a:t>
            </a:fld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125989" y="223990"/>
            <a:ext cx="15339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of Contents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2430384"/>
              </p:ext>
            </p:extLst>
          </p:nvPr>
        </p:nvGraphicFramePr>
        <p:xfrm>
          <a:off x="1089795" y="531767"/>
          <a:ext cx="8128000" cy="5933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304947">
                  <a:extLst>
                    <a:ext uri="{9D8B030D-6E8A-4147-A177-3AD203B41FA5}">
                      <a16:colId xmlns:a16="http://schemas.microsoft.com/office/drawing/2014/main" val="1434147863"/>
                    </a:ext>
                  </a:extLst>
                </a:gridCol>
                <a:gridCol w="823053">
                  <a:extLst>
                    <a:ext uri="{9D8B030D-6E8A-4147-A177-3AD203B41FA5}">
                      <a16:colId xmlns:a16="http://schemas.microsoft.com/office/drawing/2014/main" val="37022112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s and Imag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ge No.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353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1: 1H-NMR of 5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19330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2: 13C-NMR of 5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70846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3: 1H-NMR of 5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02252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4: 13C-NMR of 5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86086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5: 1H-NMR of 5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49582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6: 13C-NMR of 5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17949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7: 1H-NMR of 5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08092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8: 13C-NMR of 5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14458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9: 1H-NMR of 5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27885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10: 13C-NMR of 5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5814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11: 1H-NMR of 5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74925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12: 13C-NMR of 5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50413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13: 10-point dose response curv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31081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14: Original images for the Western blots</a:t>
                      </a:r>
                      <a:r>
                        <a:rPr lang="en-US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24 hours time point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5733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S15: Original images for the Western blots</a:t>
                      </a:r>
                      <a:r>
                        <a:rPr lang="en-US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48 hours time point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18326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611928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1348338" y="325490"/>
            <a:ext cx="9886950" cy="5852714"/>
            <a:chOff x="1348468" y="513184"/>
            <a:chExt cx="9886950" cy="5931742"/>
          </a:xfrm>
        </p:grpSpPr>
        <p:sp>
          <p:nvSpPr>
            <p:cNvPr id="3" name="TextBox 2"/>
            <p:cNvSpPr txBox="1"/>
            <p:nvPr/>
          </p:nvSpPr>
          <p:spPr>
            <a:xfrm>
              <a:off x="1708536" y="2135522"/>
              <a:ext cx="804617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>
              <a:grayscl/>
            </a:blip>
            <a:stretch>
              <a:fillRect/>
            </a:stretch>
          </p:blipFill>
          <p:spPr>
            <a:xfrm>
              <a:off x="1348468" y="513184"/>
              <a:ext cx="9886950" cy="59317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1708536" y="2679240"/>
              <a:ext cx="2127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H-NMR – Solvent: DMSO-d6</a:t>
              </a:r>
            </a:p>
          </p:txBody>
        </p:sp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92296705"/>
                </p:ext>
              </p:extLst>
            </p:nvPr>
          </p:nvGraphicFramePr>
          <p:xfrm>
            <a:off x="1840425" y="1591803"/>
            <a:ext cx="1863725" cy="1087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1863378" imgH="1088033" progId="ChemDraw.Document.6.0">
                    <p:embed/>
                  </p:oleObj>
                </mc:Choice>
                <mc:Fallback>
                  <p:oleObj name="CS ChemDraw Drawing" r:id="rId3" imgW="1863378" imgH="1088033" progId="ChemDraw.Document.6.0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840425" y="1591803"/>
                          <a:ext cx="1863725" cy="1087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Rectangle 10"/>
            <p:cNvSpPr/>
            <p:nvPr/>
          </p:nvSpPr>
          <p:spPr>
            <a:xfrm>
              <a:off x="3505641" y="2149126"/>
              <a:ext cx="681135" cy="2841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610600" y="6351460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3</a:t>
            </a:fld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B2C47C7-3B26-4697-9B69-91E40BC6C7B8}"/>
              </a:ext>
            </a:extLst>
          </p:cNvPr>
          <p:cNvSpPr txBox="1"/>
          <p:nvPr/>
        </p:nvSpPr>
        <p:spPr>
          <a:xfrm>
            <a:off x="1348338" y="6255511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of compound 5a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9314963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528262" y="382900"/>
            <a:ext cx="9858375" cy="5623443"/>
            <a:chOff x="1246478" y="873003"/>
            <a:chExt cx="9858375" cy="5623443"/>
          </a:xfrm>
        </p:grpSpPr>
        <p:sp>
          <p:nvSpPr>
            <p:cNvPr id="3" name="TextBox 2"/>
            <p:cNvSpPr txBox="1"/>
            <p:nvPr/>
          </p:nvSpPr>
          <p:spPr>
            <a:xfrm>
              <a:off x="3994535" y="2490086"/>
              <a:ext cx="804617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>
              <a:grayscl/>
            </a:blip>
            <a:stretch>
              <a:fillRect/>
            </a:stretch>
          </p:blipFill>
          <p:spPr>
            <a:xfrm>
              <a:off x="1246478" y="873003"/>
              <a:ext cx="9858375" cy="56234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Rectangle 7"/>
            <p:cNvSpPr/>
            <p:nvPr/>
          </p:nvSpPr>
          <p:spPr>
            <a:xfrm>
              <a:off x="3405673" y="2859418"/>
              <a:ext cx="991170" cy="3409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798100" y="2828834"/>
              <a:ext cx="2196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C-NMR – Solvent: DMSO-d6</a:t>
              </a:r>
            </a:p>
          </p:txBody>
        </p:sp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67937306"/>
                </p:ext>
              </p:extLst>
            </p:nvPr>
          </p:nvGraphicFramePr>
          <p:xfrm>
            <a:off x="1964456" y="1540556"/>
            <a:ext cx="1863725" cy="1087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1863378" imgH="1088033" progId="ChemDraw.Document.6.0">
                    <p:embed/>
                  </p:oleObj>
                </mc:Choice>
                <mc:Fallback>
                  <p:oleObj name="CS ChemDraw Drawing" r:id="rId3" imgW="1863378" imgH="1088033" progId="ChemDraw.Document.6.0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964456" y="1540556"/>
                          <a:ext cx="1863725" cy="1087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519160" y="6043529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4</a:t>
            </a:fld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8F7532C-E579-48E3-A80D-5DD1A22D8771}"/>
              </a:ext>
            </a:extLst>
          </p:cNvPr>
          <p:cNvSpPr txBox="1"/>
          <p:nvPr/>
        </p:nvSpPr>
        <p:spPr>
          <a:xfrm>
            <a:off x="1528262" y="6207184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of compound 5a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0076173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837472" y="760495"/>
            <a:ext cx="8934462" cy="5178292"/>
            <a:chOff x="1919287" y="1063691"/>
            <a:chExt cx="8934462" cy="530853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t="15683"/>
            <a:stretch/>
          </p:blipFill>
          <p:spPr>
            <a:xfrm>
              <a:off x="1919287" y="1063691"/>
              <a:ext cx="8934462" cy="53085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Rectangle 6"/>
            <p:cNvSpPr/>
            <p:nvPr/>
          </p:nvSpPr>
          <p:spPr>
            <a:xfrm>
              <a:off x="2006082" y="1408921"/>
              <a:ext cx="233265" cy="1959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69404" y="2317555"/>
              <a:ext cx="2127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H-NMR – Solvent: DMSO-d6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2006082" y="1063691"/>
              <a:ext cx="233265" cy="3452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4107096"/>
                </p:ext>
              </p:extLst>
            </p:nvPr>
          </p:nvGraphicFramePr>
          <p:xfrm>
            <a:off x="2122714" y="1287785"/>
            <a:ext cx="2020887" cy="1082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4" imgW="2021669" imgH="1083410" progId="ChemDraw.Document.6.0">
                    <p:embed/>
                  </p:oleObj>
                </mc:Choice>
                <mc:Fallback>
                  <p:oleObj name="CS ChemDraw Drawing" r:id="rId4" imgW="2021669" imgH="1083410" progId="ChemDraw.Document.6.0">
                    <p:embed/>
                    <p:pic>
                      <p:nvPicPr>
                        <p:cNvPr id="12" name="Object 11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122714" y="1287785"/>
                          <a:ext cx="2020887" cy="10826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528785" y="6053154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5</a:t>
            </a:fld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C1443B1-A359-4831-B5C1-18452C543625}"/>
              </a:ext>
            </a:extLst>
          </p:cNvPr>
          <p:cNvSpPr txBox="1"/>
          <p:nvPr/>
        </p:nvSpPr>
        <p:spPr>
          <a:xfrm>
            <a:off x="1791100" y="6053154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of compound 5b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8794666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668412" y="475860"/>
            <a:ext cx="9191151" cy="5439747"/>
            <a:chOff x="1726163" y="933060"/>
            <a:chExt cx="9191151" cy="543974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t="1020"/>
            <a:stretch/>
          </p:blipFill>
          <p:spPr>
            <a:xfrm>
              <a:off x="1726163" y="933060"/>
              <a:ext cx="9191151" cy="54397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TextBox 3"/>
            <p:cNvSpPr txBox="1"/>
            <p:nvPr/>
          </p:nvSpPr>
          <p:spPr>
            <a:xfrm>
              <a:off x="1936679" y="3416948"/>
              <a:ext cx="22459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C-NMR – Solvent: DMSO-d6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1814715" y="939834"/>
              <a:ext cx="238524" cy="3452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23431663"/>
                </p:ext>
              </p:extLst>
            </p:nvPr>
          </p:nvGraphicFramePr>
          <p:xfrm>
            <a:off x="2080304" y="2334273"/>
            <a:ext cx="2020887" cy="1082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4" imgW="2021669" imgH="1083410" progId="ChemDraw.Document.6.0">
                    <p:embed/>
                  </p:oleObj>
                </mc:Choice>
                <mc:Fallback>
                  <p:oleObj name="CS ChemDraw Drawing" r:id="rId4" imgW="2021669" imgH="1083410" progId="ChemDraw.Document.6.0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080304" y="2334273"/>
                          <a:ext cx="2020887" cy="10826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>
          <a:xfrm>
            <a:off x="8552849" y="5899150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6</a:t>
            </a:fld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6413EE-1259-4CE0-B3F9-76C93155D30E}"/>
              </a:ext>
            </a:extLst>
          </p:cNvPr>
          <p:cNvSpPr txBox="1"/>
          <p:nvPr/>
        </p:nvSpPr>
        <p:spPr>
          <a:xfrm>
            <a:off x="1586014" y="6187934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of compound 5b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276214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632857" y="510041"/>
            <a:ext cx="9507894" cy="5346440"/>
            <a:chOff x="1632857" y="765111"/>
            <a:chExt cx="9507894" cy="5346440"/>
          </a:xfrm>
        </p:grpSpPr>
        <p:pic>
          <p:nvPicPr>
            <p:cNvPr id="2" name="Picture 1" descr="A screenshot of a graph&#10;&#10;Description automatically generated">
              <a:extLst>
                <a:ext uri="{FF2B5EF4-FFF2-40B4-BE49-F238E27FC236}">
                  <a16:creationId xmlns:a16="http://schemas.microsoft.com/office/drawing/2014/main" id="{1EA21C25-2B49-F9ED-B2BA-A9B61EB8B2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t="20423"/>
            <a:stretch/>
          </p:blipFill>
          <p:spPr>
            <a:xfrm>
              <a:off x="1632857" y="765111"/>
              <a:ext cx="9507894" cy="53464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1870205"/>
                </p:ext>
              </p:extLst>
            </p:nvPr>
          </p:nvGraphicFramePr>
          <p:xfrm>
            <a:off x="2232448" y="1586204"/>
            <a:ext cx="2352675" cy="1082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4" imgW="2352851" imgH="1083025" progId="ChemDraw.Document.6.0">
                    <p:embed/>
                  </p:oleObj>
                </mc:Choice>
                <mc:Fallback>
                  <p:oleObj name="CS ChemDraw Drawing" r:id="rId4" imgW="2352851" imgH="1083025" progId="ChemDraw.Document.6.0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232448" y="1586204"/>
                          <a:ext cx="2352675" cy="10826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2345032" y="2654593"/>
              <a:ext cx="2127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H-NMR – Solvent: DMSO-d6</a:t>
              </a:r>
            </a:p>
          </p:txBody>
        </p:sp>
      </p:grp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101280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7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798B4E-56D9-498F-9B35-CDC8AE1B2A84}"/>
              </a:ext>
            </a:extLst>
          </p:cNvPr>
          <p:cNvSpPr txBox="1"/>
          <p:nvPr/>
        </p:nvSpPr>
        <p:spPr>
          <a:xfrm>
            <a:off x="1694848" y="6101280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of compound 5c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2251988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graph&#10;&#10;Description automatically generated">
            <a:extLst>
              <a:ext uri="{FF2B5EF4-FFF2-40B4-BE49-F238E27FC236}">
                <a16:creationId xmlns:a16="http://schemas.microsoft.com/office/drawing/2014/main" id="{20F9E4AD-B06A-F466-86D7-EAC66FD6069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20282"/>
          <a:stretch/>
        </p:blipFill>
        <p:spPr>
          <a:xfrm>
            <a:off x="1439663" y="416833"/>
            <a:ext cx="9598221" cy="5446215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364023"/>
              </p:ext>
            </p:extLst>
          </p:nvPr>
        </p:nvGraphicFramePr>
        <p:xfrm>
          <a:off x="1889963" y="1455447"/>
          <a:ext cx="2352675" cy="1082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352851" imgH="1083025" progId="ChemDraw.Document.6.0">
                  <p:embed/>
                </p:oleObj>
              </mc:Choice>
              <mc:Fallback>
                <p:oleObj name="CS ChemDraw Drawing" r:id="rId4" imgW="2352851" imgH="1083025" progId="ChemDraw.Document.6.0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89963" y="1455447"/>
                        <a:ext cx="2352675" cy="1082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968082" y="2538122"/>
            <a:ext cx="2196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– Solvent: DMSO-d6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548035" y="5952089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8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EF2986-90E8-4DC0-9730-9BD77BFD35A6}"/>
              </a:ext>
            </a:extLst>
          </p:cNvPr>
          <p:cNvSpPr txBox="1"/>
          <p:nvPr/>
        </p:nvSpPr>
        <p:spPr>
          <a:xfrm>
            <a:off x="1528262" y="6207184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C-NMR of compound 5c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884309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138924" y="494717"/>
            <a:ext cx="10351196" cy="5600587"/>
            <a:chOff x="1119674" y="793101"/>
            <a:chExt cx="10351196" cy="560058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FF0AB43-279C-93B4-1AF9-C57A34702C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grayscl/>
            </a:blip>
            <a:srcRect t="20693"/>
            <a:stretch/>
          </p:blipFill>
          <p:spPr>
            <a:xfrm>
              <a:off x="1119674" y="793101"/>
              <a:ext cx="10351196" cy="56005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57163586"/>
                </p:ext>
              </p:extLst>
            </p:nvPr>
          </p:nvGraphicFramePr>
          <p:xfrm>
            <a:off x="1949677" y="1402929"/>
            <a:ext cx="2022475" cy="1195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2022053" imgH="1195912" progId="ChemDraw.Document.6.0">
                    <p:embed/>
                  </p:oleObj>
                </mc:Choice>
                <mc:Fallback>
                  <p:oleObj name="CS ChemDraw Drawing" r:id="rId3" imgW="2022053" imgH="1195912" progId="ChemDraw.Document.6.0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949677" y="1402929"/>
                          <a:ext cx="2022475" cy="1195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1949677" y="2598316"/>
              <a:ext cx="2127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H-NMR – Solvent: DMSO-d6</a:t>
              </a:r>
            </a:p>
          </p:txBody>
        </p:sp>
      </p:grp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29850" y="6057966"/>
            <a:ext cx="2743200" cy="365125"/>
          </a:xfrm>
        </p:spPr>
        <p:txBody>
          <a:bodyPr/>
          <a:lstStyle/>
          <a:p>
            <a:fld id="{8FDCD9C0-BFF2-459C-8E88-8490473887CB}" type="slidenum">
              <a:rPr lang="en-US" smtClean="0"/>
              <a:t>9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079F46-DA01-480A-B4AE-7596A463B71A}"/>
              </a:ext>
            </a:extLst>
          </p:cNvPr>
          <p:cNvSpPr txBox="1"/>
          <p:nvPr/>
        </p:nvSpPr>
        <p:spPr>
          <a:xfrm>
            <a:off x="1348338" y="6255511"/>
            <a:ext cx="10005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H-NMR of compound 5d in DMSO-d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096571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d478348-dccf-472b-adef-2e6b15e1a930" xsi:nil="true"/>
    <MigrationWizIdPermissions xmlns="8d478348-dccf-472b-adef-2e6b15e1a930" xsi:nil="true"/>
    <MigrationWizIdDocumentLibraryPermissions xmlns="8d478348-dccf-472b-adef-2e6b15e1a930" xsi:nil="true"/>
    <MigrationWizIdSecurityGroups xmlns="8d478348-dccf-472b-adef-2e6b15e1a930" xsi:nil="true"/>
    <MigrationWizId xmlns="8d478348-dccf-472b-adef-2e6b15e1a930" xsi:nil="true"/>
    <MigrationWizIdPermissionLevels xmlns="8d478348-dccf-472b-adef-2e6b15e1a930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C8B9A715873C94FB3981FCCD29D3AD3" ma:contentTypeVersion="23" ma:contentTypeDescription="Create a new document." ma:contentTypeScope="" ma:versionID="b0061baae6eda397f020d155d43a0c71">
  <xsd:schema xmlns:xsd="http://www.w3.org/2001/XMLSchema" xmlns:xs="http://www.w3.org/2001/XMLSchema" xmlns:p="http://schemas.microsoft.com/office/2006/metadata/properties" xmlns:ns3="8d478348-dccf-472b-adef-2e6b15e1a930" xmlns:ns4="23218ed2-35d3-4964-b28b-f073301d0a5b" targetNamespace="http://schemas.microsoft.com/office/2006/metadata/properties" ma:root="true" ma:fieldsID="e5640c1d366ea15d1b90d72ba7895ed4" ns3:_="" ns4:_="">
    <xsd:import namespace="8d478348-dccf-472b-adef-2e6b15e1a930"/>
    <xsd:import namespace="23218ed2-35d3-4964-b28b-f073301d0a5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igrationWizId" minOccurs="0"/>
                <xsd:element ref="ns3:MigrationWizIdPermissions" minOccurs="0"/>
                <xsd:element ref="ns3:MigrationWizIdPermissionLevels" minOccurs="0"/>
                <xsd:element ref="ns3:MigrationWizIdDocumentLibraryPermissions" minOccurs="0"/>
                <xsd:element ref="ns3:MigrationWizIdSecurityGroup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CR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d478348-dccf-472b-adef-2e6b15e1a93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igrationWizId" ma:index="12" nillable="true" ma:displayName="MigrationWizId" ma:internalName="MigrationWizId">
      <xsd:simpleType>
        <xsd:restriction base="dms:Text"/>
      </xsd:simpleType>
    </xsd:element>
    <xsd:element name="MigrationWizIdPermissions" ma:index="13" nillable="true" ma:displayName="MigrationWizIdPermissions" ma:internalName="MigrationWizIdPermissions">
      <xsd:simpleType>
        <xsd:restriction base="dms:Text"/>
      </xsd:simpleType>
    </xsd:element>
    <xsd:element name="MigrationWizIdPermissionLevels" ma:index="14" nillable="true" ma:displayName="MigrationWizIdPermissionLevels" ma:internalName="MigrationWizIdPermissionLevels">
      <xsd:simpleType>
        <xsd:restriction base="dms:Text"/>
      </xsd:simpleType>
    </xsd:element>
    <xsd:element name="MigrationWizIdDocumentLibraryPermissions" ma:index="15" nillable="true" ma:displayName="MigrationWizIdDocumentLibraryPermissions" ma:internalName="MigrationWizIdDocumentLibraryPermissions">
      <xsd:simpleType>
        <xsd:restriction base="dms:Text"/>
      </xsd:simpleType>
    </xsd:element>
    <xsd:element name="MigrationWizIdSecurityGroups" ma:index="16" nillable="true" ma:displayName="MigrationWizIdSecurityGroups" ma:internalName="MigrationWizIdSecurityGroups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8" nillable="true" ma:displayName="Length (seconds)" ma:internalName="MediaLengthInSeconds" ma:readOnly="true">
      <xsd:simpleType>
        <xsd:restriction base="dms:Unknown"/>
      </xsd:simpleType>
    </xsd:element>
    <xsd:element name="MediaServiceAutoTags" ma:index="19" nillable="true" ma:displayName="Tags" ma:internalName="MediaServiceAutoTags" ma:readOnly="true">
      <xsd:simpleType>
        <xsd:restriction base="dms:Text"/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6" nillable="true" ma:displayName="Location" ma:internalName="MediaServiceLocation" ma:readOnly="true">
      <xsd:simpleType>
        <xsd:restriction base="dms:Text"/>
      </xsd:simpleType>
    </xsd:element>
    <xsd:element name="_activity" ma:index="27" nillable="true" ma:displayName="_activity" ma:hidden="true" ma:internalName="_activity">
      <xsd:simpleType>
        <xsd:restriction base="dms:Note"/>
      </xsd:simpleType>
    </xsd:element>
    <xsd:element name="MediaServiceObjectDetectorVersions" ma:index="28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3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3218ed2-35d3-4964-b28b-f073301d0a5b" elementFormDefault="qualified">
    <xsd:import namespace="http://schemas.microsoft.com/office/2006/documentManagement/types"/>
    <xsd:import namespace="http://schemas.microsoft.com/office/infopath/2007/PartnerControls"/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ADA2DE3-1710-491E-B524-2B2257556491}">
  <ds:schemaRefs>
    <ds:schemaRef ds:uri="http://schemas.openxmlformats.org/package/2006/metadata/core-properties"/>
    <ds:schemaRef ds:uri="23218ed2-35d3-4964-b28b-f073301d0a5b"/>
    <ds:schemaRef ds:uri="http://purl.org/dc/terms/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8d478348-dccf-472b-adef-2e6b15e1a930"/>
    <ds:schemaRef ds:uri="http://www.w3.org/XML/1998/namespace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60F94DA0-2A78-4950-97A4-9DE92FD7238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EB2FC77-24F3-44B9-A551-0538523DD13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d478348-dccf-472b-adef-2e6b15e1a930"/>
    <ds:schemaRef ds:uri="23218ed2-35d3-4964-b28b-f073301d0a5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163</TotalTime>
  <Words>849</Words>
  <Application>Microsoft Office PowerPoint</Application>
  <PresentationFormat>Widescreen</PresentationFormat>
  <Paragraphs>283</Paragraphs>
  <Slides>1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3" baseType="lpstr">
      <vt:lpstr>Arial</vt:lpstr>
      <vt:lpstr>Calibri</vt:lpstr>
      <vt:lpstr>Calibri Light</vt:lpstr>
      <vt:lpstr>Times New Roman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alakshmi Sridhar</dc:creator>
  <cp:lastModifiedBy>Jayalakshmi Sridhar</cp:lastModifiedBy>
  <cp:revision>34</cp:revision>
  <dcterms:created xsi:type="dcterms:W3CDTF">2024-03-06T20:47:58Z</dcterms:created>
  <dcterms:modified xsi:type="dcterms:W3CDTF">2024-12-02T23:46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C8B9A715873C94FB3981FCCD29D3AD3</vt:lpwstr>
  </property>
</Properties>
</file>